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64" r:id="rId2"/>
    <p:sldId id="267" r:id="rId3"/>
    <p:sldId id="268" r:id="rId4"/>
    <p:sldId id="269" r:id="rId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na Pedret" initials="AP" lastIdx="2" clrIdx="0">
    <p:extLst>
      <p:ext uri="{19B8F6BF-5375-455C-9EA6-DF929625EA0E}">
        <p15:presenceInfo xmlns:p15="http://schemas.microsoft.com/office/powerpoint/2012/main" userId="Anna Pedret" providerId="None"/>
      </p:ext>
    </p:extLst>
  </p:cmAuthor>
  <p:cmAuthor id="2" name="Judit Companys Alemany" initials="JCA" lastIdx="1" clrIdx="1">
    <p:extLst>
      <p:ext uri="{19B8F6BF-5375-455C-9EA6-DF929625EA0E}">
        <p15:presenceInfo xmlns:p15="http://schemas.microsoft.com/office/powerpoint/2012/main" userId="S::47118684-x@epp.urv.cat::82a4b7bd-d5b9-4e50-9950-7421a937d3d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A15812-FC94-48CC-AD13-5E687D8D5289}" v="3" dt="2022-03-27T17:40:55.99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623" autoAdjust="0"/>
    <p:restoredTop sz="96190"/>
  </p:normalViewPr>
  <p:slideViewPr>
    <p:cSldViewPr snapToGrid="0" snapToObjects="1">
      <p:cViewPr>
        <p:scale>
          <a:sx n="125" d="100"/>
          <a:sy n="125" d="100"/>
        </p:scale>
        <p:origin x="-2718" y="-7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dit Companys Alemany" userId="1afcf270-4732-4a08-903b-67794d9b3a0d" providerId="ADAL" clId="{2DA15812-FC94-48CC-AD13-5E687D8D5289}"/>
    <pc:docChg chg="undo custSel modSld">
      <pc:chgData name="Judit Companys Alemany" userId="1afcf270-4732-4a08-903b-67794d9b3a0d" providerId="ADAL" clId="{2DA15812-FC94-48CC-AD13-5E687D8D5289}" dt="2022-03-27T17:51:09.434" v="581" actId="20577"/>
      <pc:docMkLst>
        <pc:docMk/>
      </pc:docMkLst>
      <pc:sldChg chg="addSp modSp mod">
        <pc:chgData name="Judit Companys Alemany" userId="1afcf270-4732-4a08-903b-67794d9b3a0d" providerId="ADAL" clId="{2DA15812-FC94-48CC-AD13-5E687D8D5289}" dt="2022-03-27T17:32:20.671" v="450" actId="1035"/>
        <pc:sldMkLst>
          <pc:docMk/>
          <pc:sldMk cId="1743151859" sldId="267"/>
        </pc:sldMkLst>
        <pc:spChg chg="add mod">
          <ac:chgData name="Judit Companys Alemany" userId="1afcf270-4732-4a08-903b-67794d9b3a0d" providerId="ADAL" clId="{2DA15812-FC94-48CC-AD13-5E687D8D5289}" dt="2022-03-27T17:32:20.671" v="450" actId="1035"/>
          <ac:spMkLst>
            <pc:docMk/>
            <pc:sldMk cId="1743151859" sldId="267"/>
            <ac:spMk id="7" creationId="{66CAE95E-51EE-4EA1-ADDC-831C3366D6D3}"/>
          </ac:spMkLst>
        </pc:spChg>
        <pc:spChg chg="add mod">
          <ac:chgData name="Judit Companys Alemany" userId="1afcf270-4732-4a08-903b-67794d9b3a0d" providerId="ADAL" clId="{2DA15812-FC94-48CC-AD13-5E687D8D5289}" dt="2022-03-27T17:31:35.765" v="445" actId="114"/>
          <ac:spMkLst>
            <pc:docMk/>
            <pc:sldMk cId="1743151859" sldId="267"/>
            <ac:spMk id="9" creationId="{9CA12A00-7FF5-4D4C-9964-5D55FAAA5C8A}"/>
          </ac:spMkLst>
        </pc:spChg>
        <pc:spChg chg="add mod">
          <ac:chgData name="Judit Companys Alemany" userId="1afcf270-4732-4a08-903b-67794d9b3a0d" providerId="ADAL" clId="{2DA15812-FC94-48CC-AD13-5E687D8D5289}" dt="2022-03-27T17:29:14.672" v="399" actId="21"/>
          <ac:spMkLst>
            <pc:docMk/>
            <pc:sldMk cId="1743151859" sldId="267"/>
            <ac:spMk id="10" creationId="{CB1CDAD7-2182-4C1A-88ED-77F57E9E0A73}"/>
          </ac:spMkLst>
        </pc:spChg>
        <pc:spChg chg="add mod">
          <ac:chgData name="Judit Companys Alemany" userId="1afcf270-4732-4a08-903b-67794d9b3a0d" providerId="ADAL" clId="{2DA15812-FC94-48CC-AD13-5E687D8D5289}" dt="2022-03-27T17:29:53.343" v="412" actId="21"/>
          <ac:spMkLst>
            <pc:docMk/>
            <pc:sldMk cId="1743151859" sldId="267"/>
            <ac:spMk id="12" creationId="{FD955CA4-A044-45F9-9170-A958732B4146}"/>
          </ac:spMkLst>
        </pc:spChg>
        <pc:spChg chg="add mod">
          <ac:chgData name="Judit Companys Alemany" userId="1afcf270-4732-4a08-903b-67794d9b3a0d" providerId="ADAL" clId="{2DA15812-FC94-48CC-AD13-5E687D8D5289}" dt="2022-03-27T17:31:01.735" v="442" actId="1036"/>
          <ac:spMkLst>
            <pc:docMk/>
            <pc:sldMk cId="1743151859" sldId="267"/>
            <ac:spMk id="14" creationId="{005297EE-AA76-48F0-95AA-E02604272A20}"/>
          </ac:spMkLst>
        </pc:spChg>
        <pc:picChg chg="mod">
          <ac:chgData name="Judit Companys Alemany" userId="1afcf270-4732-4a08-903b-67794d9b3a0d" providerId="ADAL" clId="{2DA15812-FC94-48CC-AD13-5E687D8D5289}" dt="2022-03-27T17:29:22.039" v="402" actId="1076"/>
          <ac:picMkLst>
            <pc:docMk/>
            <pc:sldMk cId="1743151859" sldId="267"/>
            <ac:picMk id="5" creationId="{B474AF2F-B02E-884D-A2D8-CAAF006FD26D}"/>
          </ac:picMkLst>
        </pc:picChg>
      </pc:sldChg>
      <pc:sldChg chg="addSp modSp mod">
        <pc:chgData name="Judit Companys Alemany" userId="1afcf270-4732-4a08-903b-67794d9b3a0d" providerId="ADAL" clId="{2DA15812-FC94-48CC-AD13-5E687D8D5289}" dt="2022-03-27T17:51:09.434" v="581" actId="20577"/>
        <pc:sldMkLst>
          <pc:docMk/>
          <pc:sldMk cId="3951278731" sldId="268"/>
        </pc:sldMkLst>
        <pc:spChg chg="add mod">
          <ac:chgData name="Judit Companys Alemany" userId="1afcf270-4732-4a08-903b-67794d9b3a0d" providerId="ADAL" clId="{2DA15812-FC94-48CC-AD13-5E687D8D5289}" dt="2022-03-27T16:47:51.288" v="51" actId="790"/>
          <ac:spMkLst>
            <pc:docMk/>
            <pc:sldMk cId="3951278731" sldId="268"/>
            <ac:spMk id="2" creationId="{435DABC9-3D5E-4452-B391-07C0B3DD50C2}"/>
          </ac:spMkLst>
        </pc:spChg>
        <pc:spChg chg="add mod">
          <ac:chgData name="Judit Companys Alemany" userId="1afcf270-4732-4a08-903b-67794d9b3a0d" providerId="ADAL" clId="{2DA15812-FC94-48CC-AD13-5E687D8D5289}" dt="2022-03-27T17:51:09.434" v="581" actId="20577"/>
          <ac:spMkLst>
            <pc:docMk/>
            <pc:sldMk cId="3951278731" sldId="268"/>
            <ac:spMk id="5" creationId="{F61E5445-4D12-4EA8-BB8F-50CA712DCF8E}"/>
          </ac:spMkLst>
        </pc:spChg>
        <pc:picChg chg="mod">
          <ac:chgData name="Judit Companys Alemany" userId="1afcf270-4732-4a08-903b-67794d9b3a0d" providerId="ADAL" clId="{2DA15812-FC94-48CC-AD13-5E687D8D5289}" dt="2022-03-27T16:47:39.028" v="46" actId="1076"/>
          <ac:picMkLst>
            <pc:docMk/>
            <pc:sldMk cId="3951278731" sldId="268"/>
            <ac:picMk id="6" creationId="{079831E5-5B0C-42A8-B73A-BF1FD53782AB}"/>
          </ac:picMkLst>
        </pc:picChg>
      </pc:sldChg>
    </pc:docChg>
  </pc:docChgLst>
  <pc:docChgLst>
    <pc:chgData name="Judit Companys Alemany" userId="1afcf270-4732-4a08-903b-67794d9b3a0d" providerId="ADAL" clId="{B91EC816-A957-DC42-94C1-7CCCCBA6A3FC}"/>
    <pc:docChg chg="undo custSel addSld delSld modSld sldOrd">
      <pc:chgData name="Judit Companys Alemany" userId="1afcf270-4732-4a08-903b-67794d9b3a0d" providerId="ADAL" clId="{B91EC816-A957-DC42-94C1-7CCCCBA6A3FC}" dt="2021-05-09T19:12:12.400" v="274" actId="1076"/>
      <pc:docMkLst>
        <pc:docMk/>
      </pc:docMkLst>
      <pc:sldChg chg="add del">
        <pc:chgData name="Judit Companys Alemany" userId="1afcf270-4732-4a08-903b-67794d9b3a0d" providerId="ADAL" clId="{B91EC816-A957-DC42-94C1-7CCCCBA6A3FC}" dt="2021-05-05T18:19:39.772" v="3" actId="2696"/>
        <pc:sldMkLst>
          <pc:docMk/>
          <pc:sldMk cId="1056111066" sldId="259"/>
        </pc:sldMkLst>
      </pc:sldChg>
      <pc:sldChg chg="addSp delSp modSp add mod">
        <pc:chgData name="Judit Companys Alemany" userId="1afcf270-4732-4a08-903b-67794d9b3a0d" providerId="ADAL" clId="{B91EC816-A957-DC42-94C1-7CCCCBA6A3FC}" dt="2021-05-09T18:07:50.434" v="69" actId="20577"/>
        <pc:sldMkLst>
          <pc:docMk/>
          <pc:sldMk cId="3126424153" sldId="264"/>
        </pc:sldMkLst>
        <pc:spChg chg="add del mod">
          <ac:chgData name="Judit Companys Alemany" userId="1afcf270-4732-4a08-903b-67794d9b3a0d" providerId="ADAL" clId="{B91EC816-A957-DC42-94C1-7CCCCBA6A3FC}" dt="2021-05-09T18:07:37.012" v="64" actId="1076"/>
          <ac:spMkLst>
            <pc:docMk/>
            <pc:sldMk cId="3126424153" sldId="264"/>
            <ac:spMk id="33" creationId="{595CFCEA-E4D3-F542-B9FA-C4C9AEDE29BA}"/>
          </ac:spMkLst>
        </pc:spChg>
        <pc:spChg chg="add mod">
          <ac:chgData name="Judit Companys Alemany" userId="1afcf270-4732-4a08-903b-67794d9b3a0d" providerId="ADAL" clId="{B91EC816-A957-DC42-94C1-7CCCCBA6A3FC}" dt="2021-05-09T18:07:50.434" v="69" actId="20577"/>
          <ac:spMkLst>
            <pc:docMk/>
            <pc:sldMk cId="3126424153" sldId="264"/>
            <ac:spMk id="51" creationId="{9577B35C-3AC6-DC47-8BB9-52B57E1BCC5A}"/>
          </ac:spMkLst>
        </pc:spChg>
        <pc:spChg chg="mod">
          <ac:chgData name="Judit Companys Alemany" userId="1afcf270-4732-4a08-903b-67794d9b3a0d" providerId="ADAL" clId="{B91EC816-A957-DC42-94C1-7CCCCBA6A3FC}" dt="2021-05-09T18:07:41.993" v="66" actId="1076"/>
          <ac:spMkLst>
            <pc:docMk/>
            <pc:sldMk cId="3126424153" sldId="264"/>
            <ac:spMk id="60" creationId="{39656553-385F-B14F-B67B-9D4C5940EC39}"/>
          </ac:spMkLst>
        </pc:spChg>
        <pc:graphicFrameChg chg="mod">
          <ac:chgData name="Judit Companys Alemany" userId="1afcf270-4732-4a08-903b-67794d9b3a0d" providerId="ADAL" clId="{B91EC816-A957-DC42-94C1-7CCCCBA6A3FC}" dt="2021-05-09T18:07:26.907" v="57"/>
          <ac:graphicFrameMkLst>
            <pc:docMk/>
            <pc:sldMk cId="3126424153" sldId="264"/>
            <ac:graphicFrameMk id="65" creationId="{74CC3D46-7BC3-1348-BDF2-F56F00446E9D}"/>
          </ac:graphicFrameMkLst>
        </pc:graphicFrameChg>
        <pc:picChg chg="del">
          <ac:chgData name="Judit Companys Alemany" userId="1afcf270-4732-4a08-903b-67794d9b3a0d" providerId="ADAL" clId="{B91EC816-A957-DC42-94C1-7CCCCBA6A3FC}" dt="2021-05-09T18:07:33.653" v="63" actId="478"/>
          <ac:picMkLst>
            <pc:docMk/>
            <pc:sldMk cId="3126424153" sldId="264"/>
            <ac:picMk id="52" creationId="{0E4DB4FF-3B33-3A4D-A18A-C100FBE3446C}"/>
          </ac:picMkLst>
        </pc:picChg>
        <pc:picChg chg="del">
          <ac:chgData name="Judit Companys Alemany" userId="1afcf270-4732-4a08-903b-67794d9b3a0d" providerId="ADAL" clId="{B91EC816-A957-DC42-94C1-7CCCCBA6A3FC}" dt="2021-05-09T18:07:38.001" v="65" actId="478"/>
          <ac:picMkLst>
            <pc:docMk/>
            <pc:sldMk cId="3126424153" sldId="264"/>
            <ac:picMk id="57" creationId="{0EE12A71-5BB5-EA46-A90D-34E693E1F20A}"/>
          </ac:picMkLst>
        </pc:picChg>
      </pc:sldChg>
      <pc:sldChg chg="del">
        <pc:chgData name="Judit Companys Alemany" userId="1afcf270-4732-4a08-903b-67794d9b3a0d" providerId="ADAL" clId="{B91EC816-A957-DC42-94C1-7CCCCBA6A3FC}" dt="2021-05-05T18:19:31.135" v="0" actId="2696"/>
        <pc:sldMkLst>
          <pc:docMk/>
          <pc:sldMk cId="4240669316" sldId="264"/>
        </pc:sldMkLst>
      </pc:sldChg>
      <pc:sldChg chg="addSp modSp mod">
        <pc:chgData name="Judit Companys Alemany" userId="1afcf270-4732-4a08-903b-67794d9b3a0d" providerId="ADAL" clId="{B91EC816-A957-DC42-94C1-7CCCCBA6A3FC}" dt="2021-05-09T18:07:20.270" v="54" actId="20577"/>
        <pc:sldMkLst>
          <pc:docMk/>
          <pc:sldMk cId="1743151859" sldId="267"/>
        </pc:sldMkLst>
        <pc:spChg chg="add mod">
          <ac:chgData name="Judit Companys Alemany" userId="1afcf270-4732-4a08-903b-67794d9b3a0d" providerId="ADAL" clId="{B91EC816-A957-DC42-94C1-7CCCCBA6A3FC}" dt="2021-05-09T18:07:20.270" v="54" actId="20577"/>
          <ac:spMkLst>
            <pc:docMk/>
            <pc:sldMk cId="1743151859" sldId="267"/>
            <ac:spMk id="2" creationId="{F31FB5EB-FC7A-D745-AA07-81F0AD4C7F4F}"/>
          </ac:spMkLst>
        </pc:spChg>
      </pc:sldChg>
      <pc:sldChg chg="addSp modSp mod">
        <pc:chgData name="Judit Companys Alemany" userId="1afcf270-4732-4a08-903b-67794d9b3a0d" providerId="ADAL" clId="{B91EC816-A957-DC42-94C1-7CCCCBA6A3FC}" dt="2021-05-09T18:07:22.853" v="56" actId="20577"/>
        <pc:sldMkLst>
          <pc:docMk/>
          <pc:sldMk cId="3951278731" sldId="268"/>
        </pc:sldMkLst>
        <pc:spChg chg="add mod">
          <ac:chgData name="Judit Companys Alemany" userId="1afcf270-4732-4a08-903b-67794d9b3a0d" providerId="ADAL" clId="{B91EC816-A957-DC42-94C1-7CCCCBA6A3FC}" dt="2021-05-09T18:07:22.853" v="56" actId="20577"/>
          <ac:spMkLst>
            <pc:docMk/>
            <pc:sldMk cId="3951278731" sldId="268"/>
            <ac:spMk id="3" creationId="{73B0DE1A-ACFE-BA43-A97C-6C1D4888B174}"/>
          </ac:spMkLst>
        </pc:spChg>
      </pc:sldChg>
      <pc:sldChg chg="new del ord">
        <pc:chgData name="Judit Companys Alemany" userId="1afcf270-4732-4a08-903b-67794d9b3a0d" providerId="ADAL" clId="{B91EC816-A957-DC42-94C1-7CCCCBA6A3FC}" dt="2021-05-09T18:07:28.339" v="58" actId="2696"/>
        <pc:sldMkLst>
          <pc:docMk/>
          <pc:sldMk cId="2891530812" sldId="269"/>
        </pc:sldMkLst>
      </pc:sldChg>
      <pc:sldChg chg="addSp delSp modSp new mod">
        <pc:chgData name="Judit Companys Alemany" userId="1afcf270-4732-4a08-903b-67794d9b3a0d" providerId="ADAL" clId="{B91EC816-A957-DC42-94C1-7CCCCBA6A3FC}" dt="2021-05-09T19:12:12.400" v="274" actId="1076"/>
        <pc:sldMkLst>
          <pc:docMk/>
          <pc:sldMk cId="3383216746" sldId="269"/>
        </pc:sldMkLst>
        <pc:spChg chg="del">
          <ac:chgData name="Judit Companys Alemany" userId="1afcf270-4732-4a08-903b-67794d9b3a0d" providerId="ADAL" clId="{B91EC816-A957-DC42-94C1-7CCCCBA6A3FC}" dt="2021-05-09T18:31:06.291" v="71" actId="478"/>
          <ac:spMkLst>
            <pc:docMk/>
            <pc:sldMk cId="3383216746" sldId="269"/>
            <ac:spMk id="2" creationId="{36B8FD65-5B9C-5840-B404-D1FB863AB4A3}"/>
          </ac:spMkLst>
        </pc:spChg>
        <pc:spChg chg="add del mod">
          <ac:chgData name="Judit Companys Alemany" userId="1afcf270-4732-4a08-903b-67794d9b3a0d" providerId="ADAL" clId="{B91EC816-A957-DC42-94C1-7CCCCBA6A3FC}" dt="2021-05-09T19:06:44.238" v="130" actId="478"/>
          <ac:spMkLst>
            <pc:docMk/>
            <pc:sldMk cId="3383216746" sldId="269"/>
            <ac:spMk id="2" creationId="{C10798FA-AE9C-7C4E-AFFD-E66D80B6F70B}"/>
          </ac:spMkLst>
        </pc:spChg>
        <pc:spChg chg="del">
          <ac:chgData name="Judit Companys Alemany" userId="1afcf270-4732-4a08-903b-67794d9b3a0d" providerId="ADAL" clId="{B91EC816-A957-DC42-94C1-7CCCCBA6A3FC}" dt="2021-05-09T18:31:07.369" v="72" actId="478"/>
          <ac:spMkLst>
            <pc:docMk/>
            <pc:sldMk cId="3383216746" sldId="269"/>
            <ac:spMk id="3" creationId="{C2A5FC97-C8BC-7C42-8870-0D47B46D3E8D}"/>
          </ac:spMkLst>
        </pc:spChg>
        <pc:spChg chg="add mod">
          <ac:chgData name="Judit Companys Alemany" userId="1afcf270-4732-4a08-903b-67794d9b3a0d" providerId="ADAL" clId="{B91EC816-A957-DC42-94C1-7CCCCBA6A3FC}" dt="2021-05-09T19:09:09.164" v="194" actId="1036"/>
          <ac:spMkLst>
            <pc:docMk/>
            <pc:sldMk cId="3383216746" sldId="269"/>
            <ac:spMk id="5" creationId="{89FCC47A-BD6B-6046-958F-40022670D8F7}"/>
          </ac:spMkLst>
        </pc:spChg>
        <pc:spChg chg="add mod">
          <ac:chgData name="Judit Companys Alemany" userId="1afcf270-4732-4a08-903b-67794d9b3a0d" providerId="ADAL" clId="{B91EC816-A957-DC42-94C1-7CCCCBA6A3FC}" dt="2021-05-09T19:08:26.575" v="171" actId="1076"/>
          <ac:spMkLst>
            <pc:docMk/>
            <pc:sldMk cId="3383216746" sldId="269"/>
            <ac:spMk id="6" creationId="{D4860A1B-C708-2941-A111-FDAAA47ED9B6}"/>
          </ac:spMkLst>
        </pc:spChg>
        <pc:spChg chg="add mod">
          <ac:chgData name="Judit Companys Alemany" userId="1afcf270-4732-4a08-903b-67794d9b3a0d" providerId="ADAL" clId="{B91EC816-A957-DC42-94C1-7CCCCBA6A3FC}" dt="2021-05-09T19:08:26.575" v="171" actId="1076"/>
          <ac:spMkLst>
            <pc:docMk/>
            <pc:sldMk cId="3383216746" sldId="269"/>
            <ac:spMk id="7" creationId="{6E87FD81-E0D1-5F48-8670-0736A923872E}"/>
          </ac:spMkLst>
        </pc:spChg>
        <pc:spChg chg="add mod">
          <ac:chgData name="Judit Companys Alemany" userId="1afcf270-4732-4a08-903b-67794d9b3a0d" providerId="ADAL" clId="{B91EC816-A957-DC42-94C1-7CCCCBA6A3FC}" dt="2021-05-09T19:09:26.539" v="206" actId="1076"/>
          <ac:spMkLst>
            <pc:docMk/>
            <pc:sldMk cId="3383216746" sldId="269"/>
            <ac:spMk id="13" creationId="{B7FFF335-614F-A842-AE81-2EF6ADD695F9}"/>
          </ac:spMkLst>
        </pc:spChg>
        <pc:spChg chg="add mod">
          <ac:chgData name="Judit Companys Alemany" userId="1afcf270-4732-4a08-903b-67794d9b3a0d" providerId="ADAL" clId="{B91EC816-A957-DC42-94C1-7CCCCBA6A3FC}" dt="2021-05-09T19:11:42.087" v="264" actId="1076"/>
          <ac:spMkLst>
            <pc:docMk/>
            <pc:sldMk cId="3383216746" sldId="269"/>
            <ac:spMk id="14" creationId="{7A5B0E0E-A117-F64A-B4EC-2C21EC0D907A}"/>
          </ac:spMkLst>
        </pc:spChg>
        <pc:spChg chg="add mod">
          <ac:chgData name="Judit Companys Alemany" userId="1afcf270-4732-4a08-903b-67794d9b3a0d" providerId="ADAL" clId="{B91EC816-A957-DC42-94C1-7CCCCBA6A3FC}" dt="2021-05-09T19:09:38.462" v="212" actId="20577"/>
          <ac:spMkLst>
            <pc:docMk/>
            <pc:sldMk cId="3383216746" sldId="269"/>
            <ac:spMk id="15" creationId="{B939E64E-D7D4-1642-B54E-D5D00C0857AD}"/>
          </ac:spMkLst>
        </pc:spChg>
        <pc:spChg chg="add mod">
          <ac:chgData name="Judit Companys Alemany" userId="1afcf270-4732-4a08-903b-67794d9b3a0d" providerId="ADAL" clId="{B91EC816-A957-DC42-94C1-7CCCCBA6A3FC}" dt="2021-05-09T19:09:43.848" v="215" actId="20577"/>
          <ac:spMkLst>
            <pc:docMk/>
            <pc:sldMk cId="3383216746" sldId="269"/>
            <ac:spMk id="16" creationId="{3B2BFAF3-9652-C044-8E3B-D8F02183BEF0}"/>
          </ac:spMkLst>
        </pc:spChg>
        <pc:spChg chg="add mod">
          <ac:chgData name="Judit Companys Alemany" userId="1afcf270-4732-4a08-903b-67794d9b3a0d" providerId="ADAL" clId="{B91EC816-A957-DC42-94C1-7CCCCBA6A3FC}" dt="2021-05-09T19:10:43.317" v="244" actId="1076"/>
          <ac:spMkLst>
            <pc:docMk/>
            <pc:sldMk cId="3383216746" sldId="269"/>
            <ac:spMk id="17" creationId="{9FCB40EE-767D-904B-B87A-6EA878B6F4C6}"/>
          </ac:spMkLst>
        </pc:spChg>
        <pc:spChg chg="add del mod">
          <ac:chgData name="Judit Companys Alemany" userId="1afcf270-4732-4a08-903b-67794d9b3a0d" providerId="ADAL" clId="{B91EC816-A957-DC42-94C1-7CCCCBA6A3FC}" dt="2021-05-09T19:11:19.050" v="258" actId="478"/>
          <ac:spMkLst>
            <pc:docMk/>
            <pc:sldMk cId="3383216746" sldId="269"/>
            <ac:spMk id="18" creationId="{49FE6A68-7DDB-F348-A905-4BA19CC95722}"/>
          </ac:spMkLst>
        </pc:spChg>
        <pc:spChg chg="add del mod">
          <ac:chgData name="Judit Companys Alemany" userId="1afcf270-4732-4a08-903b-67794d9b3a0d" providerId="ADAL" clId="{B91EC816-A957-DC42-94C1-7CCCCBA6A3FC}" dt="2021-05-09T19:12:01.467" v="270" actId="478"/>
          <ac:spMkLst>
            <pc:docMk/>
            <pc:sldMk cId="3383216746" sldId="269"/>
            <ac:spMk id="19" creationId="{6F9CFD05-CB6F-1B42-950C-65EB231D1F52}"/>
          </ac:spMkLst>
        </pc:spChg>
        <pc:spChg chg="add mod">
          <ac:chgData name="Judit Companys Alemany" userId="1afcf270-4732-4a08-903b-67794d9b3a0d" providerId="ADAL" clId="{B91EC816-A957-DC42-94C1-7CCCCBA6A3FC}" dt="2021-05-09T19:10:32.214" v="242" actId="14100"/>
          <ac:spMkLst>
            <pc:docMk/>
            <pc:sldMk cId="3383216746" sldId="269"/>
            <ac:spMk id="20" creationId="{26E875A4-91B0-BF46-8BF7-E5E1937BEAA6}"/>
          </ac:spMkLst>
        </pc:spChg>
        <pc:spChg chg="add mod">
          <ac:chgData name="Judit Companys Alemany" userId="1afcf270-4732-4a08-903b-67794d9b3a0d" providerId="ADAL" clId="{B91EC816-A957-DC42-94C1-7CCCCBA6A3FC}" dt="2021-05-09T19:11:55.021" v="268" actId="1076"/>
          <ac:spMkLst>
            <pc:docMk/>
            <pc:sldMk cId="3383216746" sldId="269"/>
            <ac:spMk id="21" creationId="{948352D0-31F3-C440-9411-D69F5C5B1386}"/>
          </ac:spMkLst>
        </pc:spChg>
        <pc:spChg chg="add mod">
          <ac:chgData name="Judit Companys Alemany" userId="1afcf270-4732-4a08-903b-67794d9b3a0d" providerId="ADAL" clId="{B91EC816-A957-DC42-94C1-7CCCCBA6A3FC}" dt="2021-05-09T19:11:50.706" v="267" actId="1076"/>
          <ac:spMkLst>
            <pc:docMk/>
            <pc:sldMk cId="3383216746" sldId="269"/>
            <ac:spMk id="22" creationId="{2D6D805C-CC05-E64A-AEDF-698982A27A46}"/>
          </ac:spMkLst>
        </pc:spChg>
        <pc:spChg chg="add mod">
          <ac:chgData name="Judit Companys Alemany" userId="1afcf270-4732-4a08-903b-67794d9b3a0d" providerId="ADAL" clId="{B91EC816-A957-DC42-94C1-7CCCCBA6A3FC}" dt="2021-05-09T19:12:10.322" v="273" actId="1076"/>
          <ac:spMkLst>
            <pc:docMk/>
            <pc:sldMk cId="3383216746" sldId="269"/>
            <ac:spMk id="23" creationId="{E67712DF-D80E-694A-83A6-3F2C15481681}"/>
          </ac:spMkLst>
        </pc:spChg>
        <pc:spChg chg="add mod">
          <ac:chgData name="Judit Companys Alemany" userId="1afcf270-4732-4a08-903b-67794d9b3a0d" providerId="ADAL" clId="{B91EC816-A957-DC42-94C1-7CCCCBA6A3FC}" dt="2021-05-09T19:12:12.400" v="274" actId="1076"/>
          <ac:spMkLst>
            <pc:docMk/>
            <pc:sldMk cId="3383216746" sldId="269"/>
            <ac:spMk id="24" creationId="{8185DB71-BAB9-DE4C-B869-0A8D17DF727E}"/>
          </ac:spMkLst>
        </pc:spChg>
        <pc:picChg chg="add mod">
          <ac:chgData name="Judit Companys Alemany" userId="1afcf270-4732-4a08-903b-67794d9b3a0d" providerId="ADAL" clId="{B91EC816-A957-DC42-94C1-7CCCCBA6A3FC}" dt="2021-05-09T19:08:26.575" v="171" actId="1076"/>
          <ac:picMkLst>
            <pc:docMk/>
            <pc:sldMk cId="3383216746" sldId="269"/>
            <ac:picMk id="4" creationId="{6D37789C-01B3-634C-9FD6-478F83C6A320}"/>
          </ac:picMkLst>
        </pc:picChg>
        <pc:picChg chg="add mod">
          <ac:chgData name="Judit Companys Alemany" userId="1afcf270-4732-4a08-903b-67794d9b3a0d" providerId="ADAL" clId="{B91EC816-A957-DC42-94C1-7CCCCBA6A3FC}" dt="2021-05-09T19:09:09.164" v="194" actId="1036"/>
          <ac:picMkLst>
            <pc:docMk/>
            <pc:sldMk cId="3383216746" sldId="269"/>
            <ac:picMk id="8" creationId="{804CFDCA-17D2-D144-ADEA-649B75472DE0}"/>
          </ac:picMkLst>
        </pc:picChg>
        <pc:picChg chg="add mod">
          <ac:chgData name="Judit Companys Alemany" userId="1afcf270-4732-4a08-903b-67794d9b3a0d" providerId="ADAL" clId="{B91EC816-A957-DC42-94C1-7CCCCBA6A3FC}" dt="2021-05-09T19:10:58.066" v="249" actId="14100"/>
          <ac:picMkLst>
            <pc:docMk/>
            <pc:sldMk cId="3383216746" sldId="269"/>
            <ac:picMk id="10" creationId="{B4627764-E30F-5048-9073-B131C3394DE3}"/>
          </ac:picMkLst>
        </pc:picChg>
        <pc:picChg chg="add mod">
          <ac:chgData name="Judit Companys Alemany" userId="1afcf270-4732-4a08-903b-67794d9b3a0d" providerId="ADAL" clId="{B91EC816-A957-DC42-94C1-7CCCCBA6A3FC}" dt="2021-05-09T19:11:44.364" v="266" actId="1076"/>
          <ac:picMkLst>
            <pc:docMk/>
            <pc:sldMk cId="3383216746" sldId="269"/>
            <ac:picMk id="12" creationId="{CBCB0E76-026C-0C40-B4E6-8B298F031777}"/>
          </ac:picMkLst>
        </pc:picChg>
      </pc:sldChg>
    </pc:docChg>
  </pc:docChgLst>
  <pc:docChgLst>
    <pc:chgData name="Judit Companys Alemany" userId="1afcf270-4732-4a08-903b-67794d9b3a0d" providerId="ADAL" clId="{ECAAC020-D3BD-4CC8-8B7E-E9209157059B}"/>
    <pc:docChg chg="undo custSel addSld delSld modSld modMainMaster modNotesMaster">
      <pc:chgData name="Judit Companys Alemany" userId="1afcf270-4732-4a08-903b-67794d9b3a0d" providerId="ADAL" clId="{ECAAC020-D3BD-4CC8-8B7E-E9209157059B}" dt="2022-03-04T15:51:34.204" v="289" actId="47"/>
      <pc:docMkLst>
        <pc:docMk/>
      </pc:docMkLst>
      <pc:sldChg chg="modSp modNotes">
        <pc:chgData name="Judit Companys Alemany" userId="1afcf270-4732-4a08-903b-67794d9b3a0d" providerId="ADAL" clId="{ECAAC020-D3BD-4CC8-8B7E-E9209157059B}" dt="2022-02-24T16:24:47.357" v="107"/>
        <pc:sldMkLst>
          <pc:docMk/>
          <pc:sldMk cId="3126424153" sldId="264"/>
        </pc:sldMkLst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2" creationId="{F710FBE6-4820-3240-BFAF-1DC146227D94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13" creationId="{D02EDDFE-BF30-CD44-9E33-2FE383BEDCB8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17" creationId="{EDDA99A4-4C5A-F94D-8645-CC40DE0BDF6E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18" creationId="{053E48C8-EA8D-EA44-8033-D9DE834D6699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19" creationId="{79B00906-6E8C-9D41-BE9E-405AC302E9CA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23" creationId="{140FEC7D-BC7C-5A46-8364-1C588B92AC33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29" creationId="{C75BB791-FFF3-584E-BE76-4B88297257DB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33" creationId="{595CFCEA-E4D3-F542-B9FA-C4C9AEDE29BA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34" creationId="{EE4BE1DC-1E82-BB4D-88E8-9C0EB67F81BF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41" creationId="{03AEC4A1-8194-3149-A4AD-BCAC80F8C92B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44" creationId="{594285D1-708B-F449-87C3-C935A1901CF7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45" creationId="{92B8428B-336B-1549-9560-3E7F663321C0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46" creationId="{02BD9706-7F21-F547-8135-6793750AFDA9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47" creationId="{9C3765F1-171E-BC4A-B119-7B9C195FF9CD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48" creationId="{2DCE9F90-8B8D-224F-AE80-0CC24DFECE6C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49" creationId="{FD445F1F-1238-064E-B0E0-A6414D9A1ABD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51" creationId="{9577B35C-3AC6-DC47-8BB9-52B57E1BCC5A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53" creationId="{606AED2A-48D3-AF40-A9C8-631DBA84E1F9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54" creationId="{3B4B0484-70F5-F54E-B462-1BF671D07BE6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55" creationId="{90D26091-68F5-9B45-A82F-330ADAB4DF92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56" creationId="{03C37715-B7AB-1748-B82D-05D01C79FD39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59" creationId="{C2C7D2E0-8D2C-714F-9C36-300CEF80C75E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60" creationId="{39656553-385F-B14F-B67B-9D4C5940EC39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62" creationId="{707F764E-364C-CF44-A4FC-387D077E0497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83" creationId="{F653BCA4-4B6A-FE4F-B977-35E01F3A3B63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84" creationId="{3C498FC3-3DE4-2C43-BAD7-99903DA47C7C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85" creationId="{83A821B4-5C02-5047-823F-BE1ABB5CC607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126424153" sldId="264"/>
            <ac:spMk id="86" creationId="{1044BF2B-3D55-994A-9C38-BD428988E1AF}"/>
          </ac:spMkLst>
        </pc:spChg>
        <pc:graphicFrameChg chg="mod">
          <ac:chgData name="Judit Companys Alemany" userId="1afcf270-4732-4a08-903b-67794d9b3a0d" providerId="ADAL" clId="{ECAAC020-D3BD-4CC8-8B7E-E9209157059B}" dt="2022-02-24T16:24:47.357" v="107"/>
          <ac:graphicFrameMkLst>
            <pc:docMk/>
            <pc:sldMk cId="3126424153" sldId="264"/>
            <ac:graphicFrameMk id="50" creationId="{34431B2B-41F9-4646-B0C5-C397A1895F21}"/>
          </ac:graphicFrameMkLst>
        </pc:graphicFrameChg>
        <pc:graphicFrameChg chg="mod">
          <ac:chgData name="Judit Companys Alemany" userId="1afcf270-4732-4a08-903b-67794d9b3a0d" providerId="ADAL" clId="{ECAAC020-D3BD-4CC8-8B7E-E9209157059B}" dt="2022-02-24T16:24:47.357" v="107"/>
          <ac:graphicFrameMkLst>
            <pc:docMk/>
            <pc:sldMk cId="3126424153" sldId="264"/>
            <ac:graphicFrameMk id="65" creationId="{74CC3D46-7BC3-1348-BDF2-F56F00446E9D}"/>
          </ac:graphicFrameMkLst>
        </pc:graphicFrameChg>
        <pc:picChg chg="mod">
          <ac:chgData name="Judit Companys Alemany" userId="1afcf270-4732-4a08-903b-67794d9b3a0d" providerId="ADAL" clId="{ECAAC020-D3BD-4CC8-8B7E-E9209157059B}" dt="2022-02-24T16:24:47.357" v="107"/>
          <ac:picMkLst>
            <pc:docMk/>
            <pc:sldMk cId="3126424153" sldId="264"/>
            <ac:picMk id="4" creationId="{B9F3CCCA-A5B5-024A-A369-BD8EDA721DC9}"/>
          </ac:picMkLst>
        </pc:picChg>
        <pc:picChg chg="mod">
          <ac:chgData name="Judit Companys Alemany" userId="1afcf270-4732-4a08-903b-67794d9b3a0d" providerId="ADAL" clId="{ECAAC020-D3BD-4CC8-8B7E-E9209157059B}" dt="2022-02-24T16:24:47.357" v="107"/>
          <ac:picMkLst>
            <pc:docMk/>
            <pc:sldMk cId="3126424153" sldId="264"/>
            <ac:picMk id="26" creationId="{5B180D71-5034-534A-8794-68EDEF968D76}"/>
          </ac:picMkLst>
        </pc:picChg>
        <pc:cxnChg chg="mod">
          <ac:chgData name="Judit Companys Alemany" userId="1afcf270-4732-4a08-903b-67794d9b3a0d" providerId="ADAL" clId="{ECAAC020-D3BD-4CC8-8B7E-E9209157059B}" dt="2022-02-24T16:24:47.357" v="107"/>
          <ac:cxnSpMkLst>
            <pc:docMk/>
            <pc:sldMk cId="3126424153" sldId="264"/>
            <ac:cxnSpMk id="3" creationId="{59925F5E-E69D-8749-9D1B-062E2541B68E}"/>
          </ac:cxnSpMkLst>
        </pc:cxnChg>
        <pc:cxnChg chg="mod">
          <ac:chgData name="Judit Companys Alemany" userId="1afcf270-4732-4a08-903b-67794d9b3a0d" providerId="ADAL" clId="{ECAAC020-D3BD-4CC8-8B7E-E9209157059B}" dt="2022-02-24T16:24:47.357" v="107"/>
          <ac:cxnSpMkLst>
            <pc:docMk/>
            <pc:sldMk cId="3126424153" sldId="264"/>
            <ac:cxnSpMk id="6" creationId="{FCFCCAB0-CDCF-BB41-9A1F-9F87720B2145}"/>
          </ac:cxnSpMkLst>
        </pc:cxnChg>
        <pc:cxnChg chg="mod">
          <ac:chgData name="Judit Companys Alemany" userId="1afcf270-4732-4a08-903b-67794d9b3a0d" providerId="ADAL" clId="{ECAAC020-D3BD-4CC8-8B7E-E9209157059B}" dt="2022-02-24T16:24:47.357" v="107"/>
          <ac:cxnSpMkLst>
            <pc:docMk/>
            <pc:sldMk cId="3126424153" sldId="264"/>
            <ac:cxnSpMk id="22" creationId="{191DB848-5126-B34C-BE48-4D8BA565425D}"/>
          </ac:cxnSpMkLst>
        </pc:cxnChg>
        <pc:cxnChg chg="mod">
          <ac:chgData name="Judit Companys Alemany" userId="1afcf270-4732-4a08-903b-67794d9b3a0d" providerId="ADAL" clId="{ECAAC020-D3BD-4CC8-8B7E-E9209157059B}" dt="2022-02-24T16:24:47.357" v="107"/>
          <ac:cxnSpMkLst>
            <pc:docMk/>
            <pc:sldMk cId="3126424153" sldId="264"/>
            <ac:cxnSpMk id="27" creationId="{CBFD2838-D5C4-414F-A860-1896A0448B81}"/>
          </ac:cxnSpMkLst>
        </pc:cxnChg>
        <pc:cxnChg chg="mod">
          <ac:chgData name="Judit Companys Alemany" userId="1afcf270-4732-4a08-903b-67794d9b3a0d" providerId="ADAL" clId="{ECAAC020-D3BD-4CC8-8B7E-E9209157059B}" dt="2022-02-24T16:24:47.357" v="107"/>
          <ac:cxnSpMkLst>
            <pc:docMk/>
            <pc:sldMk cId="3126424153" sldId="264"/>
            <ac:cxnSpMk id="28" creationId="{0AEE2FD9-463B-2E40-BDD3-28DEFCD4C061}"/>
          </ac:cxnSpMkLst>
        </pc:cxnChg>
        <pc:cxnChg chg="mod">
          <ac:chgData name="Judit Companys Alemany" userId="1afcf270-4732-4a08-903b-67794d9b3a0d" providerId="ADAL" clId="{ECAAC020-D3BD-4CC8-8B7E-E9209157059B}" dt="2022-02-24T16:24:47.357" v="107"/>
          <ac:cxnSpMkLst>
            <pc:docMk/>
            <pc:sldMk cId="3126424153" sldId="264"/>
            <ac:cxnSpMk id="30" creationId="{E64D620F-1E7D-EA43-BD7C-0BB8B5C3C8C7}"/>
          </ac:cxnSpMkLst>
        </pc:cxnChg>
        <pc:cxnChg chg="mod">
          <ac:chgData name="Judit Companys Alemany" userId="1afcf270-4732-4a08-903b-67794d9b3a0d" providerId="ADAL" clId="{ECAAC020-D3BD-4CC8-8B7E-E9209157059B}" dt="2022-02-24T16:24:47.357" v="107"/>
          <ac:cxnSpMkLst>
            <pc:docMk/>
            <pc:sldMk cId="3126424153" sldId="264"/>
            <ac:cxnSpMk id="36" creationId="{7341A172-1332-2242-84F7-E3A1E4F37C40}"/>
          </ac:cxnSpMkLst>
        </pc:cxnChg>
        <pc:cxnChg chg="mod">
          <ac:chgData name="Judit Companys Alemany" userId="1afcf270-4732-4a08-903b-67794d9b3a0d" providerId="ADAL" clId="{ECAAC020-D3BD-4CC8-8B7E-E9209157059B}" dt="2022-02-24T16:24:47.357" v="107"/>
          <ac:cxnSpMkLst>
            <pc:docMk/>
            <pc:sldMk cId="3126424153" sldId="264"/>
            <ac:cxnSpMk id="42" creationId="{1F39FAA9-4CEA-CD4D-9B76-C36BB92DB1B8}"/>
          </ac:cxnSpMkLst>
        </pc:cxnChg>
        <pc:cxnChg chg="mod">
          <ac:chgData name="Judit Companys Alemany" userId="1afcf270-4732-4a08-903b-67794d9b3a0d" providerId="ADAL" clId="{ECAAC020-D3BD-4CC8-8B7E-E9209157059B}" dt="2022-02-24T16:24:47.357" v="107"/>
          <ac:cxnSpMkLst>
            <pc:docMk/>
            <pc:sldMk cId="3126424153" sldId="264"/>
            <ac:cxnSpMk id="43" creationId="{6EAA3B62-3602-A24D-B810-CB0733A9E41F}"/>
          </ac:cxnSpMkLst>
        </pc:cxnChg>
      </pc:sldChg>
      <pc:sldChg chg="modSp">
        <pc:chgData name="Judit Companys Alemany" userId="1afcf270-4732-4a08-903b-67794d9b3a0d" providerId="ADAL" clId="{ECAAC020-D3BD-4CC8-8B7E-E9209157059B}" dt="2022-02-24T16:24:47.357" v="107"/>
        <pc:sldMkLst>
          <pc:docMk/>
          <pc:sldMk cId="1743151859" sldId="267"/>
        </pc:sldMkLst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1743151859" sldId="267"/>
            <ac:spMk id="2" creationId="{F31FB5EB-FC7A-D745-AA07-81F0AD4C7F4F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1743151859" sldId="267"/>
            <ac:spMk id="4" creationId="{5D2C64C0-880A-A040-873D-F61C56D9055B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1743151859" sldId="267"/>
            <ac:spMk id="6" creationId="{19E23663-6E73-D840-BC4F-F49CFB5B2C91}"/>
          </ac:spMkLst>
        </pc:spChg>
        <pc:picChg chg="mod">
          <ac:chgData name="Judit Companys Alemany" userId="1afcf270-4732-4a08-903b-67794d9b3a0d" providerId="ADAL" clId="{ECAAC020-D3BD-4CC8-8B7E-E9209157059B}" dt="2022-02-24T16:24:47.357" v="107"/>
          <ac:picMkLst>
            <pc:docMk/>
            <pc:sldMk cId="1743151859" sldId="267"/>
            <ac:picMk id="5" creationId="{B474AF2F-B02E-884D-A2D8-CAAF006FD26D}"/>
          </ac:picMkLst>
        </pc:picChg>
      </pc:sldChg>
      <pc:sldChg chg="addSp delSp modSp mod">
        <pc:chgData name="Judit Companys Alemany" userId="1afcf270-4732-4a08-903b-67794d9b3a0d" providerId="ADAL" clId="{ECAAC020-D3BD-4CC8-8B7E-E9209157059B}" dt="2022-02-24T16:24:47.357" v="107"/>
        <pc:sldMkLst>
          <pc:docMk/>
          <pc:sldMk cId="3951278731" sldId="268"/>
        </pc:sldMkLst>
        <pc:spChg chg="mod ord">
          <ac:chgData name="Judit Companys Alemany" userId="1afcf270-4732-4a08-903b-67794d9b3a0d" providerId="ADAL" clId="{ECAAC020-D3BD-4CC8-8B7E-E9209157059B}" dt="2022-02-24T16:24:47.357" v="107"/>
          <ac:spMkLst>
            <pc:docMk/>
            <pc:sldMk cId="3951278731" sldId="268"/>
            <ac:spMk id="3" creationId="{73B0DE1A-ACFE-BA43-A97C-6C1D4888B174}"/>
          </ac:spMkLst>
        </pc:spChg>
        <pc:picChg chg="add del mod modCrop">
          <ac:chgData name="Judit Companys Alemany" userId="1afcf270-4732-4a08-903b-67794d9b3a0d" providerId="ADAL" clId="{ECAAC020-D3BD-4CC8-8B7E-E9209157059B}" dt="2022-02-24T16:19:47.314" v="11" actId="478"/>
          <ac:picMkLst>
            <pc:docMk/>
            <pc:sldMk cId="3951278731" sldId="268"/>
            <ac:picMk id="4" creationId="{82017CEB-72A4-4496-856B-DF559A9B29A4}"/>
          </ac:picMkLst>
        </pc:picChg>
        <pc:picChg chg="add mod modCrop">
          <ac:chgData name="Judit Companys Alemany" userId="1afcf270-4732-4a08-903b-67794d9b3a0d" providerId="ADAL" clId="{ECAAC020-D3BD-4CC8-8B7E-E9209157059B}" dt="2022-02-24T16:24:47.357" v="107"/>
          <ac:picMkLst>
            <pc:docMk/>
            <pc:sldMk cId="3951278731" sldId="268"/>
            <ac:picMk id="6" creationId="{079831E5-5B0C-42A8-B73A-BF1FD53782AB}"/>
          </ac:picMkLst>
        </pc:picChg>
        <pc:picChg chg="del mod">
          <ac:chgData name="Judit Companys Alemany" userId="1afcf270-4732-4a08-903b-67794d9b3a0d" providerId="ADAL" clId="{ECAAC020-D3BD-4CC8-8B7E-E9209157059B}" dt="2022-02-24T16:19:33.716" v="5" actId="478"/>
          <ac:picMkLst>
            <pc:docMk/>
            <pc:sldMk cId="3951278731" sldId="268"/>
            <ac:picMk id="7" creationId="{99976F12-BECE-5441-9118-787D37577E02}"/>
          </ac:picMkLst>
        </pc:picChg>
      </pc:sldChg>
      <pc:sldChg chg="addSp delSp modSp mod">
        <pc:chgData name="Judit Companys Alemany" userId="1afcf270-4732-4a08-903b-67794d9b3a0d" providerId="ADAL" clId="{ECAAC020-D3BD-4CC8-8B7E-E9209157059B}" dt="2022-02-24T16:33:36.503" v="288" actId="20577"/>
        <pc:sldMkLst>
          <pc:docMk/>
          <pc:sldMk cId="3383216746" sldId="269"/>
        </pc:sldMkLst>
        <pc:spChg chg="mod">
          <ac:chgData name="Judit Companys Alemany" userId="1afcf270-4732-4a08-903b-67794d9b3a0d" providerId="ADAL" clId="{ECAAC020-D3BD-4CC8-8B7E-E9209157059B}" dt="2022-02-24T16:31:57.101" v="255" actId="1076"/>
          <ac:spMkLst>
            <pc:docMk/>
            <pc:sldMk cId="3383216746" sldId="269"/>
            <ac:spMk id="5" creationId="{89FCC47A-BD6B-6046-958F-40022670D8F7}"/>
          </ac:spMkLst>
        </pc:spChg>
        <pc:spChg chg="del mod">
          <ac:chgData name="Judit Companys Alemany" userId="1afcf270-4732-4a08-903b-67794d9b3a0d" providerId="ADAL" clId="{ECAAC020-D3BD-4CC8-8B7E-E9209157059B}" dt="2022-02-24T16:22:25.511" v="51" actId="21"/>
          <ac:spMkLst>
            <pc:docMk/>
            <pc:sldMk cId="3383216746" sldId="269"/>
            <ac:spMk id="6" creationId="{D4860A1B-C708-2941-A111-FDAAA47ED9B6}"/>
          </ac:spMkLst>
        </pc:spChg>
        <pc:spChg chg="del mod">
          <ac:chgData name="Judit Companys Alemany" userId="1afcf270-4732-4a08-903b-67794d9b3a0d" providerId="ADAL" clId="{ECAAC020-D3BD-4CC8-8B7E-E9209157059B}" dt="2022-02-24T16:22:25.511" v="51" actId="21"/>
          <ac:spMkLst>
            <pc:docMk/>
            <pc:sldMk cId="3383216746" sldId="269"/>
            <ac:spMk id="7" creationId="{6E87FD81-E0D1-5F48-8670-0736A923872E}"/>
          </ac:spMkLst>
        </pc:spChg>
        <pc:spChg chg="mod ord">
          <ac:chgData name="Judit Companys Alemany" userId="1afcf270-4732-4a08-903b-67794d9b3a0d" providerId="ADAL" clId="{ECAAC020-D3BD-4CC8-8B7E-E9209157059B}" dt="2022-02-24T16:31:53.405" v="254" actId="1076"/>
          <ac:spMkLst>
            <pc:docMk/>
            <pc:sldMk cId="3383216746" sldId="269"/>
            <ac:spMk id="13" creationId="{B7FFF335-614F-A842-AE81-2EF6ADD695F9}"/>
          </ac:spMkLst>
        </pc:spChg>
        <pc:spChg chg="mod">
          <ac:chgData name="Judit Companys Alemany" userId="1afcf270-4732-4a08-903b-67794d9b3a0d" providerId="ADAL" clId="{ECAAC020-D3BD-4CC8-8B7E-E9209157059B}" dt="2022-02-24T16:32:52.910" v="270" actId="1076"/>
          <ac:spMkLst>
            <pc:docMk/>
            <pc:sldMk cId="3383216746" sldId="269"/>
            <ac:spMk id="14" creationId="{7A5B0E0E-A117-F64A-B4EC-2C21EC0D907A}"/>
          </ac:spMkLst>
        </pc:spChg>
        <pc:spChg chg="mod">
          <ac:chgData name="Judit Companys Alemany" userId="1afcf270-4732-4a08-903b-67794d9b3a0d" providerId="ADAL" clId="{ECAAC020-D3BD-4CC8-8B7E-E9209157059B}" dt="2022-02-24T16:32:46.038" v="268" actId="1076"/>
          <ac:spMkLst>
            <pc:docMk/>
            <pc:sldMk cId="3383216746" sldId="269"/>
            <ac:spMk id="15" creationId="{B939E64E-D7D4-1642-B54E-D5D00C0857AD}"/>
          </ac:spMkLst>
        </pc:spChg>
        <pc:spChg chg="del mod">
          <ac:chgData name="Judit Companys Alemany" userId="1afcf270-4732-4a08-903b-67794d9b3a0d" providerId="ADAL" clId="{ECAAC020-D3BD-4CC8-8B7E-E9209157059B}" dt="2022-02-24T16:22:25.511" v="51" actId="21"/>
          <ac:spMkLst>
            <pc:docMk/>
            <pc:sldMk cId="3383216746" sldId="269"/>
            <ac:spMk id="16" creationId="{3B2BFAF3-9652-C044-8E3B-D8F02183BEF0}"/>
          </ac:spMkLst>
        </pc:spChg>
        <pc:spChg chg="add del mod">
          <ac:chgData name="Judit Companys Alemany" userId="1afcf270-4732-4a08-903b-67794d9b3a0d" providerId="ADAL" clId="{ECAAC020-D3BD-4CC8-8B7E-E9209157059B}" dt="2022-02-24T16:28:40.015" v="144" actId="478"/>
          <ac:spMkLst>
            <pc:docMk/>
            <pc:sldMk cId="3383216746" sldId="269"/>
            <ac:spMk id="17" creationId="{9FCB40EE-767D-904B-B87A-6EA878B6F4C6}"/>
          </ac:spMkLst>
        </pc:spChg>
        <pc:spChg chg="add del mod">
          <ac:chgData name="Judit Companys Alemany" userId="1afcf270-4732-4a08-903b-67794d9b3a0d" providerId="ADAL" clId="{ECAAC020-D3BD-4CC8-8B7E-E9209157059B}" dt="2022-02-24T16:32:31.527" v="263" actId="1076"/>
          <ac:spMkLst>
            <pc:docMk/>
            <pc:sldMk cId="3383216746" sldId="269"/>
            <ac:spMk id="19" creationId="{17BFD4A3-B3C6-46EB-8BEE-CB99B1084538}"/>
          </ac:spMkLst>
        </pc:spChg>
        <pc:spChg chg="add del mod">
          <ac:chgData name="Judit Companys Alemany" userId="1afcf270-4732-4a08-903b-67794d9b3a0d" providerId="ADAL" clId="{ECAAC020-D3BD-4CC8-8B7E-E9209157059B}" dt="2022-02-24T16:28:40.669" v="145" actId="478"/>
          <ac:spMkLst>
            <pc:docMk/>
            <pc:sldMk cId="3383216746" sldId="269"/>
            <ac:spMk id="20" creationId="{26E875A4-91B0-BF46-8BF7-E5E1937BEAA6}"/>
          </ac:spMkLst>
        </pc:spChg>
        <pc:spChg chg="del mod">
          <ac:chgData name="Judit Companys Alemany" userId="1afcf270-4732-4a08-903b-67794d9b3a0d" providerId="ADAL" clId="{ECAAC020-D3BD-4CC8-8B7E-E9209157059B}" dt="2022-02-24T16:23:16.782" v="66" actId="478"/>
          <ac:spMkLst>
            <pc:docMk/>
            <pc:sldMk cId="3383216746" sldId="269"/>
            <ac:spMk id="21" creationId="{948352D0-31F3-C440-9411-D69F5C5B1386}"/>
          </ac:spMkLst>
        </pc:spChg>
        <pc:spChg chg="del mod">
          <ac:chgData name="Judit Companys Alemany" userId="1afcf270-4732-4a08-903b-67794d9b3a0d" providerId="ADAL" clId="{ECAAC020-D3BD-4CC8-8B7E-E9209157059B}" dt="2022-02-24T16:23:22.117" v="70" actId="478"/>
          <ac:spMkLst>
            <pc:docMk/>
            <pc:sldMk cId="3383216746" sldId="269"/>
            <ac:spMk id="22" creationId="{2D6D805C-CC05-E64A-AEDF-698982A27A46}"/>
          </ac:spMkLst>
        </pc:spChg>
        <pc:spChg chg="mod ord">
          <ac:chgData name="Judit Companys Alemany" userId="1afcf270-4732-4a08-903b-67794d9b3a0d" providerId="ADAL" clId="{ECAAC020-D3BD-4CC8-8B7E-E9209157059B}" dt="2022-02-24T16:32:31.527" v="263" actId="1076"/>
          <ac:spMkLst>
            <pc:docMk/>
            <pc:sldMk cId="3383216746" sldId="269"/>
            <ac:spMk id="23" creationId="{E67712DF-D80E-694A-83A6-3F2C15481681}"/>
          </ac:spMkLst>
        </pc:spChg>
        <pc:spChg chg="mod ord">
          <ac:chgData name="Judit Companys Alemany" userId="1afcf270-4732-4a08-903b-67794d9b3a0d" providerId="ADAL" clId="{ECAAC020-D3BD-4CC8-8B7E-E9209157059B}" dt="2022-02-24T16:32:31.527" v="263" actId="1076"/>
          <ac:spMkLst>
            <pc:docMk/>
            <pc:sldMk cId="3383216746" sldId="269"/>
            <ac:spMk id="24" creationId="{8185DB71-BAB9-DE4C-B869-0A8D17DF727E}"/>
          </ac:spMkLst>
        </pc:spChg>
        <pc:spChg chg="add del mod">
          <ac:chgData name="Judit Companys Alemany" userId="1afcf270-4732-4a08-903b-67794d9b3a0d" providerId="ADAL" clId="{ECAAC020-D3BD-4CC8-8B7E-E9209157059B}" dt="2022-02-24T16:32:31.527" v="263" actId="1076"/>
          <ac:spMkLst>
            <pc:docMk/>
            <pc:sldMk cId="3383216746" sldId="269"/>
            <ac:spMk id="25" creationId="{7998C703-8E4D-4791-AB39-2EF16865016C}"/>
          </ac:spMkLst>
        </pc:spChg>
        <pc:spChg chg="add del mod">
          <ac:chgData name="Judit Companys Alemany" userId="1afcf270-4732-4a08-903b-67794d9b3a0d" providerId="ADAL" clId="{ECAAC020-D3BD-4CC8-8B7E-E9209157059B}" dt="2022-02-24T16:24:41.160" v="97"/>
          <ac:spMkLst>
            <pc:docMk/>
            <pc:sldMk cId="3383216746" sldId="269"/>
            <ac:spMk id="26" creationId="{78B41AAA-ABC2-4514-ACA6-E36B755F0578}"/>
          </ac:spMkLst>
        </pc:spChg>
        <pc:spChg chg="add del mod">
          <ac:chgData name="Judit Companys Alemany" userId="1afcf270-4732-4a08-903b-67794d9b3a0d" providerId="ADAL" clId="{ECAAC020-D3BD-4CC8-8B7E-E9209157059B}" dt="2022-02-24T16:24:41.160" v="97"/>
          <ac:spMkLst>
            <pc:docMk/>
            <pc:sldMk cId="3383216746" sldId="269"/>
            <ac:spMk id="27" creationId="{5BAC0BE0-17DD-4608-A941-52216FFB7000}"/>
          </ac:spMkLst>
        </pc:spChg>
        <pc:spChg chg="add mod">
          <ac:chgData name="Judit Companys Alemany" userId="1afcf270-4732-4a08-903b-67794d9b3a0d" providerId="ADAL" clId="{ECAAC020-D3BD-4CC8-8B7E-E9209157059B}" dt="2022-02-24T16:33:19.358" v="275" actId="1076"/>
          <ac:spMkLst>
            <pc:docMk/>
            <pc:sldMk cId="3383216746" sldId="269"/>
            <ac:spMk id="30" creationId="{9615EB4A-15D4-4112-BD96-AECF92B831DB}"/>
          </ac:spMkLst>
        </pc:spChg>
        <pc:spChg chg="add mod">
          <ac:chgData name="Judit Companys Alemany" userId="1afcf270-4732-4a08-903b-67794d9b3a0d" providerId="ADAL" clId="{ECAAC020-D3BD-4CC8-8B7E-E9209157059B}" dt="2022-02-24T16:33:21.742" v="276" actId="14100"/>
          <ac:spMkLst>
            <pc:docMk/>
            <pc:sldMk cId="3383216746" sldId="269"/>
            <ac:spMk id="31" creationId="{0201429E-19C9-4A52-862B-FD1F6CE6CA58}"/>
          </ac:spMkLst>
        </pc:spChg>
        <pc:spChg chg="add mod">
          <ac:chgData name="Judit Companys Alemany" userId="1afcf270-4732-4a08-903b-67794d9b3a0d" providerId="ADAL" clId="{ECAAC020-D3BD-4CC8-8B7E-E9209157059B}" dt="2022-02-24T16:33:36.503" v="288" actId="20577"/>
          <ac:spMkLst>
            <pc:docMk/>
            <pc:sldMk cId="3383216746" sldId="269"/>
            <ac:spMk id="34" creationId="{60BFA2FF-7C5C-4A5E-BF90-6787D1494089}"/>
          </ac:spMkLst>
        </pc:spChg>
        <pc:picChg chg="add del mod modCrop">
          <ac:chgData name="Judit Companys Alemany" userId="1afcf270-4732-4a08-903b-67794d9b3a0d" providerId="ADAL" clId="{ECAAC020-D3BD-4CC8-8B7E-E9209157059B}" dt="2022-02-24T16:27:25.913" v="132" actId="22"/>
          <ac:picMkLst>
            <pc:docMk/>
            <pc:sldMk cId="3383216746" sldId="269"/>
            <ac:picMk id="3" creationId="{04456DFE-9F3A-4667-81E0-2A95012E9585}"/>
          </ac:picMkLst>
        </pc:picChg>
        <pc:picChg chg="add del mod">
          <ac:chgData name="Judit Companys Alemany" userId="1afcf270-4732-4a08-903b-67794d9b3a0d" providerId="ADAL" clId="{ECAAC020-D3BD-4CC8-8B7E-E9209157059B}" dt="2022-02-24T16:22:25.511" v="51" actId="21"/>
          <ac:picMkLst>
            <pc:docMk/>
            <pc:sldMk cId="3383216746" sldId="269"/>
            <ac:picMk id="4" creationId="{6D37789C-01B3-634C-9FD6-478F83C6A320}"/>
          </ac:picMkLst>
        </pc:picChg>
        <pc:picChg chg="add del mod">
          <ac:chgData name="Judit Companys Alemany" userId="1afcf270-4732-4a08-903b-67794d9b3a0d" providerId="ADAL" clId="{ECAAC020-D3BD-4CC8-8B7E-E9209157059B}" dt="2022-02-24T16:28:16.679" v="134" actId="478"/>
          <ac:picMkLst>
            <pc:docMk/>
            <pc:sldMk cId="3383216746" sldId="269"/>
            <ac:picMk id="8" creationId="{804CFDCA-17D2-D144-ADEA-649B75472DE0}"/>
          </ac:picMkLst>
        </pc:picChg>
        <pc:picChg chg="del mod">
          <ac:chgData name="Judit Companys Alemany" userId="1afcf270-4732-4a08-903b-67794d9b3a0d" providerId="ADAL" clId="{ECAAC020-D3BD-4CC8-8B7E-E9209157059B}" dt="2022-02-24T16:30:22.985" v="228" actId="478"/>
          <ac:picMkLst>
            <pc:docMk/>
            <pc:sldMk cId="3383216746" sldId="269"/>
            <ac:picMk id="10" creationId="{B4627764-E30F-5048-9073-B131C3394DE3}"/>
          </ac:picMkLst>
        </pc:picChg>
        <pc:picChg chg="add del mod">
          <ac:chgData name="Judit Companys Alemany" userId="1afcf270-4732-4a08-903b-67794d9b3a0d" providerId="ADAL" clId="{ECAAC020-D3BD-4CC8-8B7E-E9209157059B}" dt="2022-02-24T16:29:16.282" v="152" actId="478"/>
          <ac:picMkLst>
            <pc:docMk/>
            <pc:sldMk cId="3383216746" sldId="269"/>
            <ac:picMk id="12" creationId="{CBCB0E76-026C-0C40-B4E6-8B298F031777}"/>
          </ac:picMkLst>
        </pc:picChg>
        <pc:picChg chg="add mod modCrop">
          <ac:chgData name="Judit Companys Alemany" userId="1afcf270-4732-4a08-903b-67794d9b3a0d" providerId="ADAL" clId="{ECAAC020-D3BD-4CC8-8B7E-E9209157059B}" dt="2022-02-24T16:33:26.414" v="277" actId="14100"/>
          <ac:picMkLst>
            <pc:docMk/>
            <pc:sldMk cId="3383216746" sldId="269"/>
            <ac:picMk id="18" creationId="{8AF29878-4214-4E84-8CB1-62589B776F5E}"/>
          </ac:picMkLst>
        </pc:picChg>
        <pc:picChg chg="add mod ord modCrop">
          <ac:chgData name="Judit Companys Alemany" userId="1afcf270-4732-4a08-903b-67794d9b3a0d" providerId="ADAL" clId="{ECAAC020-D3BD-4CC8-8B7E-E9209157059B}" dt="2022-02-24T16:32:50.037" v="269" actId="1076"/>
          <ac:picMkLst>
            <pc:docMk/>
            <pc:sldMk cId="3383216746" sldId="269"/>
            <ac:picMk id="29" creationId="{E93B3DAD-D8A4-4BBD-9077-50F1C854C35E}"/>
          </ac:picMkLst>
        </pc:picChg>
        <pc:picChg chg="add mod modCrop">
          <ac:chgData name="Judit Companys Alemany" userId="1afcf270-4732-4a08-903b-67794d9b3a0d" providerId="ADAL" clId="{ECAAC020-D3BD-4CC8-8B7E-E9209157059B}" dt="2022-02-24T16:32:42.749" v="267" actId="1076"/>
          <ac:picMkLst>
            <pc:docMk/>
            <pc:sldMk cId="3383216746" sldId="269"/>
            <ac:picMk id="33" creationId="{03136F39-F785-4745-8BCC-5F0386A57EF2}"/>
          </ac:picMkLst>
        </pc:picChg>
      </pc:sldChg>
      <pc:sldChg chg="addSp modSp new del">
        <pc:chgData name="Judit Companys Alemany" userId="1afcf270-4732-4a08-903b-67794d9b3a0d" providerId="ADAL" clId="{ECAAC020-D3BD-4CC8-8B7E-E9209157059B}" dt="2022-03-04T15:51:34.204" v="289" actId="47"/>
        <pc:sldMkLst>
          <pc:docMk/>
          <pc:sldMk cId="1893290698" sldId="270"/>
        </pc:sldMkLst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1893290698" sldId="270"/>
            <ac:spMk id="2" creationId="{95D3DB87-531F-43BA-B3C4-C6249814BD5A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1893290698" sldId="270"/>
            <ac:spMk id="3" creationId="{A8374A05-0735-4487-B5FD-567AD170456A}"/>
          </ac:spMkLst>
        </pc:spChg>
        <pc:spChg chg="add 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1893290698" sldId="270"/>
            <ac:spMk id="5" creationId="{431AAEEF-1A34-4CBE-9DD5-7C3F0286327C}"/>
          </ac:spMkLst>
        </pc:spChg>
        <pc:spChg chg="add 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1893290698" sldId="270"/>
            <ac:spMk id="6" creationId="{B0023105-402E-4D79-833B-DD4E4ECD4128}"/>
          </ac:spMkLst>
        </pc:spChg>
        <pc:spChg chg="add mod">
          <ac:chgData name="Judit Companys Alemany" userId="1afcf270-4732-4a08-903b-67794d9b3a0d" providerId="ADAL" clId="{ECAAC020-D3BD-4CC8-8B7E-E9209157059B}" dt="2022-02-24T16:24:47.357" v="107"/>
          <ac:spMkLst>
            <pc:docMk/>
            <pc:sldMk cId="1893290698" sldId="270"/>
            <ac:spMk id="7" creationId="{B0128770-AF10-45A8-9AA4-35BC9E9DEDA7}"/>
          </ac:spMkLst>
        </pc:spChg>
        <pc:picChg chg="add mod">
          <ac:chgData name="Judit Companys Alemany" userId="1afcf270-4732-4a08-903b-67794d9b3a0d" providerId="ADAL" clId="{ECAAC020-D3BD-4CC8-8B7E-E9209157059B}" dt="2022-02-24T16:24:47.357" v="107"/>
          <ac:picMkLst>
            <pc:docMk/>
            <pc:sldMk cId="1893290698" sldId="270"/>
            <ac:picMk id="4" creationId="{131371B0-C78C-4B31-BAA4-65221A84BED0}"/>
          </ac:picMkLst>
        </pc:picChg>
      </pc:sldChg>
      <pc:sldMasterChg chg="modSp modSldLayout">
        <pc:chgData name="Judit Companys Alemany" userId="1afcf270-4732-4a08-903b-67794d9b3a0d" providerId="ADAL" clId="{ECAAC020-D3BD-4CC8-8B7E-E9209157059B}" dt="2022-02-24T16:24:47.357" v="107"/>
        <pc:sldMasterMkLst>
          <pc:docMk/>
          <pc:sldMasterMk cId="1751631703" sldId="2147483648"/>
        </pc:sldMasterMkLst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asterMk cId="1751631703" sldId="2147483648"/>
            <ac:spMk id="2" creationId="{BA81FF2A-0737-3B4E-81AE-56E63F299D4E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asterMk cId="1751631703" sldId="2147483648"/>
            <ac:spMk id="3" creationId="{AA3F46D7-6ED0-5F49-9D5E-1C41C92B108D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asterMk cId="1751631703" sldId="2147483648"/>
            <ac:spMk id="4" creationId="{6EF4AE93-C788-C34B-BC1D-766CF38DC20F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asterMk cId="1751631703" sldId="2147483648"/>
            <ac:spMk id="5" creationId="{DB7E9F54-6E88-9644-A3F5-215E985BDC87}"/>
          </ac:spMkLst>
        </pc:spChg>
        <pc:spChg chg="mod">
          <ac:chgData name="Judit Companys Alemany" userId="1afcf270-4732-4a08-903b-67794d9b3a0d" providerId="ADAL" clId="{ECAAC020-D3BD-4CC8-8B7E-E9209157059B}" dt="2022-02-24T16:24:47.357" v="107"/>
          <ac:spMkLst>
            <pc:docMk/>
            <pc:sldMasterMk cId="1751631703" sldId="2147483648"/>
            <ac:spMk id="6" creationId="{DF531A22-5E76-A24E-8EDE-017814C4771B}"/>
          </ac:spMkLst>
        </pc:spChg>
        <pc:sldLayoutChg chg="modSp">
          <pc:chgData name="Judit Companys Alemany" userId="1afcf270-4732-4a08-903b-67794d9b3a0d" providerId="ADAL" clId="{ECAAC020-D3BD-4CC8-8B7E-E9209157059B}" dt="2022-02-24T16:24:47.357" v="107"/>
          <pc:sldLayoutMkLst>
            <pc:docMk/>
            <pc:sldMasterMk cId="1751631703" sldId="2147483648"/>
            <pc:sldLayoutMk cId="575694776" sldId="2147483649"/>
          </pc:sldLayoutMkLst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575694776" sldId="2147483649"/>
              <ac:spMk id="2" creationId="{5AB2DC7D-82FE-5743-9ACF-2F646CF7E995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575694776" sldId="2147483649"/>
              <ac:spMk id="3" creationId="{B4E18524-74F6-9C41-BBE5-ABD0B6405712}"/>
            </ac:spMkLst>
          </pc:spChg>
        </pc:sldLayoutChg>
        <pc:sldLayoutChg chg="modSp">
          <pc:chgData name="Judit Companys Alemany" userId="1afcf270-4732-4a08-903b-67794d9b3a0d" providerId="ADAL" clId="{ECAAC020-D3BD-4CC8-8B7E-E9209157059B}" dt="2022-02-24T16:24:47.357" v="107"/>
          <pc:sldLayoutMkLst>
            <pc:docMk/>
            <pc:sldMasterMk cId="1751631703" sldId="2147483648"/>
            <pc:sldLayoutMk cId="183297676" sldId="2147483651"/>
          </pc:sldLayoutMkLst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183297676" sldId="2147483651"/>
              <ac:spMk id="2" creationId="{23FBF8D6-D29A-8241-A14D-54E8FA0B9E3C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183297676" sldId="2147483651"/>
              <ac:spMk id="3" creationId="{06C260DB-6483-2B4B-8BD8-C7E3F6818423}"/>
            </ac:spMkLst>
          </pc:spChg>
        </pc:sldLayoutChg>
        <pc:sldLayoutChg chg="modSp">
          <pc:chgData name="Judit Companys Alemany" userId="1afcf270-4732-4a08-903b-67794d9b3a0d" providerId="ADAL" clId="{ECAAC020-D3BD-4CC8-8B7E-E9209157059B}" dt="2022-02-24T16:24:47.357" v="107"/>
          <pc:sldLayoutMkLst>
            <pc:docMk/>
            <pc:sldMasterMk cId="1751631703" sldId="2147483648"/>
            <pc:sldLayoutMk cId="635434912" sldId="2147483652"/>
          </pc:sldLayoutMkLst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635434912" sldId="2147483652"/>
              <ac:spMk id="3" creationId="{7C53FBF9-72B6-D04E-9689-0BA26B8368A8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635434912" sldId="2147483652"/>
              <ac:spMk id="4" creationId="{CD2FF73E-7A58-5C4B-89AA-57FED7B9BF47}"/>
            </ac:spMkLst>
          </pc:spChg>
        </pc:sldLayoutChg>
        <pc:sldLayoutChg chg="modSp">
          <pc:chgData name="Judit Companys Alemany" userId="1afcf270-4732-4a08-903b-67794d9b3a0d" providerId="ADAL" clId="{ECAAC020-D3BD-4CC8-8B7E-E9209157059B}" dt="2022-02-24T16:24:47.357" v="107"/>
          <pc:sldLayoutMkLst>
            <pc:docMk/>
            <pc:sldMasterMk cId="1751631703" sldId="2147483648"/>
            <pc:sldLayoutMk cId="1453560546" sldId="2147483653"/>
          </pc:sldLayoutMkLst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1453560546" sldId="2147483653"/>
              <ac:spMk id="2" creationId="{0A44E720-8773-B24E-B573-C2E94D68640D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1453560546" sldId="2147483653"/>
              <ac:spMk id="3" creationId="{A05143A9-47F6-5E49-926A-54546BDC59EF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1453560546" sldId="2147483653"/>
              <ac:spMk id="4" creationId="{D3AD1F28-D75E-4449-87BD-A285452089AE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1453560546" sldId="2147483653"/>
              <ac:spMk id="5" creationId="{5BDC6246-76F9-9745-B8E7-CD312DEF09DE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1453560546" sldId="2147483653"/>
              <ac:spMk id="6" creationId="{B3B1352B-434F-F44E-82E5-0BDA0F4003C5}"/>
            </ac:spMkLst>
          </pc:spChg>
        </pc:sldLayoutChg>
        <pc:sldLayoutChg chg="modSp">
          <pc:chgData name="Judit Companys Alemany" userId="1afcf270-4732-4a08-903b-67794d9b3a0d" providerId="ADAL" clId="{ECAAC020-D3BD-4CC8-8B7E-E9209157059B}" dt="2022-02-24T16:24:47.357" v="107"/>
          <pc:sldLayoutMkLst>
            <pc:docMk/>
            <pc:sldMasterMk cId="1751631703" sldId="2147483648"/>
            <pc:sldLayoutMk cId="3612688176" sldId="2147483656"/>
          </pc:sldLayoutMkLst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3612688176" sldId="2147483656"/>
              <ac:spMk id="2" creationId="{626D6F75-8527-BE42-98ED-7B6AE8A70D19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3612688176" sldId="2147483656"/>
              <ac:spMk id="3" creationId="{89C75D2F-ADA5-4C4D-A9F7-43446663C6E1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3612688176" sldId="2147483656"/>
              <ac:spMk id="4" creationId="{8BB2BA92-45CC-C54A-9E03-BCB405214F73}"/>
            </ac:spMkLst>
          </pc:spChg>
        </pc:sldLayoutChg>
        <pc:sldLayoutChg chg="modSp">
          <pc:chgData name="Judit Companys Alemany" userId="1afcf270-4732-4a08-903b-67794d9b3a0d" providerId="ADAL" clId="{ECAAC020-D3BD-4CC8-8B7E-E9209157059B}" dt="2022-02-24T16:24:47.357" v="107"/>
          <pc:sldLayoutMkLst>
            <pc:docMk/>
            <pc:sldMasterMk cId="1751631703" sldId="2147483648"/>
            <pc:sldLayoutMk cId="3540404450" sldId="2147483657"/>
          </pc:sldLayoutMkLst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3540404450" sldId="2147483657"/>
              <ac:spMk id="2" creationId="{EDC7B89F-6EA5-5245-ADBE-07528668A34E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3540404450" sldId="2147483657"/>
              <ac:spMk id="3" creationId="{DFC05934-9172-AD41-8962-E90F11C3111A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3540404450" sldId="2147483657"/>
              <ac:spMk id="4" creationId="{EF9D85B4-59AB-4E49-9188-17E8234B7870}"/>
            </ac:spMkLst>
          </pc:spChg>
        </pc:sldLayoutChg>
        <pc:sldLayoutChg chg="modSp">
          <pc:chgData name="Judit Companys Alemany" userId="1afcf270-4732-4a08-903b-67794d9b3a0d" providerId="ADAL" clId="{ECAAC020-D3BD-4CC8-8B7E-E9209157059B}" dt="2022-02-24T16:24:47.357" v="107"/>
          <pc:sldLayoutMkLst>
            <pc:docMk/>
            <pc:sldMasterMk cId="1751631703" sldId="2147483648"/>
            <pc:sldLayoutMk cId="1564976789" sldId="2147483659"/>
          </pc:sldLayoutMkLst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1564976789" sldId="2147483659"/>
              <ac:spMk id="2" creationId="{268FDCB9-2837-6743-800C-0C43F8CDA949}"/>
            </ac:spMkLst>
          </pc:spChg>
          <pc:spChg chg="mod">
            <ac:chgData name="Judit Companys Alemany" userId="1afcf270-4732-4a08-903b-67794d9b3a0d" providerId="ADAL" clId="{ECAAC020-D3BD-4CC8-8B7E-E9209157059B}" dt="2022-02-24T16:24:47.357" v="107"/>
            <ac:spMkLst>
              <pc:docMk/>
              <pc:sldMasterMk cId="1751631703" sldId="2147483648"/>
              <pc:sldLayoutMk cId="1564976789" sldId="2147483659"/>
              <ac:spMk id="3" creationId="{52A2AEAB-A7AC-9E47-89E7-A8B172228F9B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A5B16F-1B2E-FB4D-8249-E6C09577B899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D9CBD5-0A39-DD4E-A155-7649F0ABEC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184447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6C3ED8-2F05-9545-A912-56EE353F2C63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11254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D9CBD5-0A39-DD4E-A155-7649F0ABEC34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90976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3869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773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992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3817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550010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45437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2841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5064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8536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4819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4083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06D9F-F144-154E-8C67-D6FD3A64AF3E}" type="datetimeFigureOut">
              <a:rPr lang="es-ES" smtClean="0"/>
              <a:t>27/03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DE80F-91A0-6E4E-B2FC-6BEE9E3A73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9113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ángulo 22">
            <a:extLst>
              <a:ext uri="{FF2B5EF4-FFF2-40B4-BE49-F238E27FC236}">
                <a16:creationId xmlns:a16="http://schemas.microsoft.com/office/drawing/2014/main" id="{140FEC7D-BC7C-5A46-8364-1C588B92AC33}"/>
              </a:ext>
            </a:extLst>
          </p:cNvPr>
          <p:cNvSpPr/>
          <p:nvPr/>
        </p:nvSpPr>
        <p:spPr>
          <a:xfrm>
            <a:off x="2069603" y="1024717"/>
            <a:ext cx="8131788" cy="4730043"/>
          </a:xfrm>
          <a:prstGeom prst="rect">
            <a:avLst/>
          </a:prstGeom>
          <a:solidFill>
            <a:schemeClr val="bg2"/>
          </a:solidFill>
          <a:ln>
            <a:solidFill>
              <a:schemeClr val="bg2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 sz="1050" b="1" dirty="0"/>
          </a:p>
          <a:p>
            <a:pPr algn="ctr"/>
            <a:endParaRPr lang="es-ES" sz="1050" b="1" dirty="0"/>
          </a:p>
          <a:p>
            <a:pPr algn="ctr"/>
            <a:endParaRPr lang="es-ES" sz="1050" b="1" dirty="0"/>
          </a:p>
          <a:p>
            <a:pPr algn="ctr"/>
            <a:endParaRPr lang="es-ES" sz="1050" b="1" dirty="0"/>
          </a:p>
        </p:txBody>
      </p:sp>
      <p:sp>
        <p:nvSpPr>
          <p:cNvPr id="62" name="Rectángulo 61">
            <a:extLst>
              <a:ext uri="{FF2B5EF4-FFF2-40B4-BE49-F238E27FC236}">
                <a16:creationId xmlns:a16="http://schemas.microsoft.com/office/drawing/2014/main" id="{707F764E-364C-CF44-A4FC-387D077E0497}"/>
              </a:ext>
            </a:extLst>
          </p:cNvPr>
          <p:cNvSpPr/>
          <p:nvPr/>
        </p:nvSpPr>
        <p:spPr>
          <a:xfrm>
            <a:off x="2207774" y="1669726"/>
            <a:ext cx="2089133" cy="1124639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 sz="1050" dirty="0"/>
          </a:p>
          <a:p>
            <a:pPr algn="ctr"/>
            <a:endParaRPr lang="es-ES" sz="1050" dirty="0"/>
          </a:p>
          <a:p>
            <a:pPr algn="ctr"/>
            <a:endParaRPr lang="es-ES" sz="1050" dirty="0"/>
          </a:p>
          <a:p>
            <a:pPr algn="ctr"/>
            <a:endParaRPr lang="es-ES" sz="1050" dirty="0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B9F3CCCA-A5B5-024A-A369-BD8EDA721D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2344706" y="1729801"/>
            <a:ext cx="394767" cy="528313"/>
          </a:xfrm>
          <a:prstGeom prst="rect">
            <a:avLst/>
          </a:prstGeom>
        </p:spPr>
      </p:pic>
      <p:sp>
        <p:nvSpPr>
          <p:cNvPr id="13" name="CuadroTexto 12">
            <a:extLst>
              <a:ext uri="{FF2B5EF4-FFF2-40B4-BE49-F238E27FC236}">
                <a16:creationId xmlns:a16="http://schemas.microsoft.com/office/drawing/2014/main" id="{D02EDDFE-BF30-CD44-9E33-2FE383BEDCB8}"/>
              </a:ext>
            </a:extLst>
          </p:cNvPr>
          <p:cNvSpPr txBox="1"/>
          <p:nvPr/>
        </p:nvSpPr>
        <p:spPr>
          <a:xfrm>
            <a:off x="2115789" y="2193270"/>
            <a:ext cx="94099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b="1" dirty="0" err="1"/>
              <a:t>Screening</a:t>
            </a:r>
            <a:r>
              <a:rPr lang="es-ES" sz="1050" b="1" dirty="0"/>
              <a:t> (V0)</a:t>
            </a:r>
          </a:p>
        </p:txBody>
      </p:sp>
      <p:cxnSp>
        <p:nvCxnSpPr>
          <p:cNvPr id="22" name="Conector recto de flecha 21">
            <a:extLst>
              <a:ext uri="{FF2B5EF4-FFF2-40B4-BE49-F238E27FC236}">
                <a16:creationId xmlns:a16="http://schemas.microsoft.com/office/drawing/2014/main" id="{191DB848-5126-B34C-BE48-4D8BA565425D}"/>
              </a:ext>
            </a:extLst>
          </p:cNvPr>
          <p:cNvCxnSpPr>
            <a:cxnSpLocks/>
            <a:stCxn id="4" idx="1"/>
            <a:endCxn id="26" idx="1"/>
          </p:cNvCxnSpPr>
          <p:nvPr/>
        </p:nvCxnSpPr>
        <p:spPr>
          <a:xfrm>
            <a:off x="2739471" y="1993958"/>
            <a:ext cx="866314" cy="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Imagen 25">
            <a:extLst>
              <a:ext uri="{FF2B5EF4-FFF2-40B4-BE49-F238E27FC236}">
                <a16:creationId xmlns:a16="http://schemas.microsoft.com/office/drawing/2014/main" id="{5B180D71-5034-534A-8794-68EDEF968D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05787" y="1729802"/>
            <a:ext cx="444663" cy="528313"/>
          </a:xfrm>
          <a:prstGeom prst="rect">
            <a:avLst/>
          </a:prstGeom>
        </p:spPr>
      </p:pic>
      <p:sp>
        <p:nvSpPr>
          <p:cNvPr id="29" name="CuadroTexto 28">
            <a:extLst>
              <a:ext uri="{FF2B5EF4-FFF2-40B4-BE49-F238E27FC236}">
                <a16:creationId xmlns:a16="http://schemas.microsoft.com/office/drawing/2014/main" id="{C75BB791-FFF3-584E-BE76-4B88297257DB}"/>
              </a:ext>
            </a:extLst>
          </p:cNvPr>
          <p:cNvSpPr txBox="1"/>
          <p:nvPr/>
        </p:nvSpPr>
        <p:spPr>
          <a:xfrm>
            <a:off x="3193659" y="2213408"/>
            <a:ext cx="11448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b="1" dirty="0" err="1"/>
              <a:t>Randomization</a:t>
            </a:r>
            <a:endParaRPr lang="es-ES" sz="1050" b="1" dirty="0"/>
          </a:p>
          <a:p>
            <a:pPr algn="ctr"/>
            <a:endParaRPr lang="es-ES" sz="1050" b="1" dirty="0"/>
          </a:p>
        </p:txBody>
      </p:sp>
      <p:cxnSp>
        <p:nvCxnSpPr>
          <p:cNvPr id="42" name="Conector recto de flecha 41">
            <a:extLst>
              <a:ext uri="{FF2B5EF4-FFF2-40B4-BE49-F238E27FC236}">
                <a16:creationId xmlns:a16="http://schemas.microsoft.com/office/drawing/2014/main" id="{1F39FAA9-4CEA-CD4D-9B76-C36BB92DB1B8}"/>
              </a:ext>
            </a:extLst>
          </p:cNvPr>
          <p:cNvCxnSpPr>
            <a:cxnSpLocks/>
            <a:stCxn id="62" idx="3"/>
            <a:endCxn id="46" idx="1"/>
          </p:cNvCxnSpPr>
          <p:nvPr/>
        </p:nvCxnSpPr>
        <p:spPr>
          <a:xfrm flipV="1">
            <a:off x="4296904" y="1646235"/>
            <a:ext cx="324840" cy="58581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ctor recto de flecha 42">
            <a:extLst>
              <a:ext uri="{FF2B5EF4-FFF2-40B4-BE49-F238E27FC236}">
                <a16:creationId xmlns:a16="http://schemas.microsoft.com/office/drawing/2014/main" id="{6EAA3B62-3602-A24D-B810-CB0733A9E41F}"/>
              </a:ext>
            </a:extLst>
          </p:cNvPr>
          <p:cNvCxnSpPr>
            <a:cxnSpLocks/>
            <a:stCxn id="62" idx="3"/>
            <a:endCxn id="54" idx="1"/>
          </p:cNvCxnSpPr>
          <p:nvPr/>
        </p:nvCxnSpPr>
        <p:spPr>
          <a:xfrm>
            <a:off x="4296908" y="2232043"/>
            <a:ext cx="342625" cy="61388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ángulo 45">
            <a:extLst>
              <a:ext uri="{FF2B5EF4-FFF2-40B4-BE49-F238E27FC236}">
                <a16:creationId xmlns:a16="http://schemas.microsoft.com/office/drawing/2014/main" id="{02BD9706-7F21-F547-8135-6793750AFDA9}"/>
              </a:ext>
            </a:extLst>
          </p:cNvPr>
          <p:cNvSpPr/>
          <p:nvPr/>
        </p:nvSpPr>
        <p:spPr>
          <a:xfrm>
            <a:off x="4621744" y="1103243"/>
            <a:ext cx="3095288" cy="1085976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 sz="1050" dirty="0"/>
          </a:p>
          <a:p>
            <a:pPr algn="ctr"/>
            <a:endParaRPr lang="es-ES" sz="1050" dirty="0"/>
          </a:p>
          <a:p>
            <a:pPr algn="ctr"/>
            <a:endParaRPr lang="es-ES" sz="1050" dirty="0"/>
          </a:p>
          <a:p>
            <a:pPr algn="ctr"/>
            <a:endParaRPr lang="es-ES" sz="1050" dirty="0"/>
          </a:p>
        </p:txBody>
      </p:sp>
      <p:sp>
        <p:nvSpPr>
          <p:cNvPr id="48" name="Rectángulo 47">
            <a:extLst>
              <a:ext uri="{FF2B5EF4-FFF2-40B4-BE49-F238E27FC236}">
                <a16:creationId xmlns:a16="http://schemas.microsoft.com/office/drawing/2014/main" id="{2DCE9F90-8B8D-224F-AE80-0CC24DFECE6C}"/>
              </a:ext>
            </a:extLst>
          </p:cNvPr>
          <p:cNvSpPr/>
          <p:nvPr/>
        </p:nvSpPr>
        <p:spPr>
          <a:xfrm>
            <a:off x="5688587" y="1630686"/>
            <a:ext cx="920304" cy="49021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s-ES" sz="1050" b="1" dirty="0"/>
              <a:t>V2</a:t>
            </a:r>
          </a:p>
          <a:p>
            <a:pPr algn="ctr"/>
            <a:r>
              <a:rPr lang="es-ES" sz="1050" dirty="0"/>
              <a:t>(W6)</a:t>
            </a:r>
          </a:p>
        </p:txBody>
      </p:sp>
      <p:sp>
        <p:nvSpPr>
          <p:cNvPr id="49" name="Rectángulo 48">
            <a:extLst>
              <a:ext uri="{FF2B5EF4-FFF2-40B4-BE49-F238E27FC236}">
                <a16:creationId xmlns:a16="http://schemas.microsoft.com/office/drawing/2014/main" id="{FD445F1F-1238-064E-B0E0-A6414D9A1ABD}"/>
              </a:ext>
            </a:extLst>
          </p:cNvPr>
          <p:cNvSpPr/>
          <p:nvPr/>
        </p:nvSpPr>
        <p:spPr>
          <a:xfrm>
            <a:off x="6702809" y="1630690"/>
            <a:ext cx="920304" cy="49021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s-ES" sz="1050" b="1" dirty="0"/>
              <a:t>V3</a:t>
            </a:r>
          </a:p>
          <a:p>
            <a:pPr algn="ctr"/>
            <a:r>
              <a:rPr lang="es-ES" sz="1050" dirty="0"/>
              <a:t>(W12)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595CFCEA-E4D3-F542-B9FA-C4C9AEDE29BA}"/>
              </a:ext>
            </a:extLst>
          </p:cNvPr>
          <p:cNvSpPr txBox="1"/>
          <p:nvPr/>
        </p:nvSpPr>
        <p:spPr>
          <a:xfrm>
            <a:off x="4468220" y="1132706"/>
            <a:ext cx="2948747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Placebo</a:t>
            </a:r>
          </a:p>
          <a:p>
            <a:pPr algn="ctr"/>
            <a:r>
              <a:rPr lang="es-ES" sz="1050" dirty="0"/>
              <a:t>(</a:t>
            </a:r>
            <a:r>
              <a:rPr lang="es-ES" sz="1050" dirty="0" err="1"/>
              <a:t>conventional</a:t>
            </a:r>
            <a:r>
              <a:rPr lang="es-ES" sz="1050" dirty="0"/>
              <a:t> </a:t>
            </a:r>
            <a:r>
              <a:rPr lang="es-ES" sz="1050" dirty="0" err="1"/>
              <a:t>seafood</a:t>
            </a:r>
            <a:r>
              <a:rPr lang="es-ES" sz="1050" dirty="0"/>
              <a:t> </a:t>
            </a:r>
            <a:r>
              <a:rPr lang="es-ES" sz="1050" dirty="0" err="1"/>
              <a:t>sticks</a:t>
            </a:r>
            <a:r>
              <a:rPr lang="es-ES" sz="1050" dirty="0"/>
              <a:t>)</a:t>
            </a:r>
          </a:p>
        </p:txBody>
      </p:sp>
      <p:sp>
        <p:nvSpPr>
          <p:cNvPr id="53" name="Rectángulo 52">
            <a:extLst>
              <a:ext uri="{FF2B5EF4-FFF2-40B4-BE49-F238E27FC236}">
                <a16:creationId xmlns:a16="http://schemas.microsoft.com/office/drawing/2014/main" id="{606AED2A-48D3-AF40-A9C8-631DBA84E1F9}"/>
              </a:ext>
            </a:extLst>
          </p:cNvPr>
          <p:cNvSpPr/>
          <p:nvPr/>
        </p:nvSpPr>
        <p:spPr>
          <a:xfrm>
            <a:off x="4674366" y="1633856"/>
            <a:ext cx="920304" cy="49021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s-ES" sz="1050" b="1" dirty="0"/>
              <a:t>V1</a:t>
            </a:r>
          </a:p>
          <a:p>
            <a:pPr algn="ctr"/>
            <a:r>
              <a:rPr lang="es-ES" sz="1050" dirty="0"/>
              <a:t>(W0)</a:t>
            </a:r>
          </a:p>
        </p:txBody>
      </p:sp>
      <p:sp>
        <p:nvSpPr>
          <p:cNvPr id="54" name="Rectángulo 53">
            <a:extLst>
              <a:ext uri="{FF2B5EF4-FFF2-40B4-BE49-F238E27FC236}">
                <a16:creationId xmlns:a16="http://schemas.microsoft.com/office/drawing/2014/main" id="{3B4B0484-70F5-F54E-B462-1BF671D07BE6}"/>
              </a:ext>
            </a:extLst>
          </p:cNvPr>
          <p:cNvSpPr/>
          <p:nvPr/>
        </p:nvSpPr>
        <p:spPr>
          <a:xfrm>
            <a:off x="4639532" y="2304669"/>
            <a:ext cx="3077503" cy="1082520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 sz="1050" dirty="0"/>
          </a:p>
          <a:p>
            <a:pPr algn="ctr"/>
            <a:endParaRPr lang="es-ES" sz="1050" dirty="0"/>
          </a:p>
          <a:p>
            <a:pPr algn="ctr"/>
            <a:endParaRPr lang="es-ES" sz="1050" dirty="0"/>
          </a:p>
          <a:p>
            <a:pPr algn="ctr"/>
            <a:endParaRPr lang="es-ES" sz="1050" dirty="0"/>
          </a:p>
        </p:txBody>
      </p:sp>
      <p:sp>
        <p:nvSpPr>
          <p:cNvPr id="55" name="Rectángulo 54">
            <a:extLst>
              <a:ext uri="{FF2B5EF4-FFF2-40B4-BE49-F238E27FC236}">
                <a16:creationId xmlns:a16="http://schemas.microsoft.com/office/drawing/2014/main" id="{90D26091-68F5-9B45-A82F-330ADAB4DF92}"/>
              </a:ext>
            </a:extLst>
          </p:cNvPr>
          <p:cNvSpPr/>
          <p:nvPr/>
        </p:nvSpPr>
        <p:spPr>
          <a:xfrm>
            <a:off x="5688591" y="2826397"/>
            <a:ext cx="902519" cy="49021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s-ES" sz="1050" b="1" dirty="0"/>
              <a:t>V2</a:t>
            </a:r>
          </a:p>
          <a:p>
            <a:pPr algn="ctr"/>
            <a:r>
              <a:rPr lang="es-ES" sz="1050" dirty="0"/>
              <a:t>(W6)</a:t>
            </a:r>
          </a:p>
        </p:txBody>
      </p:sp>
      <p:sp>
        <p:nvSpPr>
          <p:cNvPr id="56" name="Rectángulo 55">
            <a:extLst>
              <a:ext uri="{FF2B5EF4-FFF2-40B4-BE49-F238E27FC236}">
                <a16:creationId xmlns:a16="http://schemas.microsoft.com/office/drawing/2014/main" id="{03C37715-B7AB-1748-B82D-05D01C79FD39}"/>
              </a:ext>
            </a:extLst>
          </p:cNvPr>
          <p:cNvSpPr/>
          <p:nvPr/>
        </p:nvSpPr>
        <p:spPr>
          <a:xfrm>
            <a:off x="6702809" y="2826002"/>
            <a:ext cx="902520" cy="49021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s-ES" sz="1050" b="1" dirty="0"/>
              <a:t>V3</a:t>
            </a:r>
          </a:p>
          <a:p>
            <a:pPr algn="ctr"/>
            <a:r>
              <a:rPr lang="es-ES" sz="1050" dirty="0"/>
              <a:t>(W12)</a:t>
            </a:r>
          </a:p>
        </p:txBody>
      </p:sp>
      <p:sp>
        <p:nvSpPr>
          <p:cNvPr id="59" name="Rectángulo 58">
            <a:extLst>
              <a:ext uri="{FF2B5EF4-FFF2-40B4-BE49-F238E27FC236}">
                <a16:creationId xmlns:a16="http://schemas.microsoft.com/office/drawing/2014/main" id="{C2C7D2E0-8D2C-714F-9C36-300CEF80C75E}"/>
              </a:ext>
            </a:extLst>
          </p:cNvPr>
          <p:cNvSpPr/>
          <p:nvPr/>
        </p:nvSpPr>
        <p:spPr>
          <a:xfrm>
            <a:off x="4674369" y="2825998"/>
            <a:ext cx="902519" cy="49021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s-ES" sz="1050" b="1" dirty="0"/>
              <a:t>V1</a:t>
            </a:r>
          </a:p>
          <a:p>
            <a:pPr algn="ctr"/>
            <a:r>
              <a:rPr lang="es-ES" sz="1050" dirty="0"/>
              <a:t> (W0)</a:t>
            </a: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39656553-385F-B14F-B67B-9D4C5940EC39}"/>
              </a:ext>
            </a:extLst>
          </p:cNvPr>
          <p:cNvSpPr txBox="1"/>
          <p:nvPr/>
        </p:nvSpPr>
        <p:spPr>
          <a:xfrm>
            <a:off x="4568493" y="2272754"/>
            <a:ext cx="310838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SIAP2</a:t>
            </a:r>
          </a:p>
          <a:p>
            <a:pPr algn="ctr"/>
            <a:r>
              <a:rPr lang="es-ES" sz="1050" dirty="0"/>
              <a:t>(</a:t>
            </a:r>
            <a:r>
              <a:rPr lang="es-ES" sz="1050" dirty="0" err="1"/>
              <a:t>seafood</a:t>
            </a:r>
            <a:r>
              <a:rPr lang="es-ES" sz="1050" dirty="0"/>
              <a:t> </a:t>
            </a:r>
            <a:r>
              <a:rPr lang="es-ES" sz="1050" dirty="0" err="1"/>
              <a:t>sticks</a:t>
            </a:r>
            <a:r>
              <a:rPr lang="es-ES" sz="1050" dirty="0"/>
              <a:t> + </a:t>
            </a:r>
            <a:r>
              <a:rPr lang="es-ES" sz="1050" dirty="0" err="1"/>
              <a:t>heat-inactivated</a:t>
            </a:r>
            <a:r>
              <a:rPr lang="es-ES" sz="1050" dirty="0"/>
              <a:t> </a:t>
            </a:r>
            <a:r>
              <a:rPr lang="en-US" sz="1050" dirty="0"/>
              <a:t>Ba8145</a:t>
            </a:r>
            <a:r>
              <a:rPr lang="es-ES" sz="1050" dirty="0"/>
              <a:t> + </a:t>
            </a:r>
            <a:r>
              <a:rPr lang="es-ES" sz="1050" dirty="0" err="1"/>
              <a:t>Inulin</a:t>
            </a:r>
            <a:r>
              <a:rPr lang="es-ES" sz="1050" dirty="0"/>
              <a:t> + Omega-3)</a:t>
            </a:r>
          </a:p>
        </p:txBody>
      </p:sp>
      <p:graphicFrame>
        <p:nvGraphicFramePr>
          <p:cNvPr id="65" name="Tabla 64">
            <a:extLst>
              <a:ext uri="{FF2B5EF4-FFF2-40B4-BE49-F238E27FC236}">
                <a16:creationId xmlns:a16="http://schemas.microsoft.com/office/drawing/2014/main" id="{74CC3D46-7BC3-1348-BDF2-F56F00446E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1772727"/>
              </p:ext>
            </p:extLst>
          </p:nvPr>
        </p:nvGraphicFramePr>
        <p:xfrm>
          <a:off x="2322647" y="3502637"/>
          <a:ext cx="5394380" cy="224681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78876">
                  <a:extLst>
                    <a:ext uri="{9D8B030D-6E8A-4147-A177-3AD203B41FA5}">
                      <a16:colId xmlns:a16="http://schemas.microsoft.com/office/drawing/2014/main" val="511266432"/>
                    </a:ext>
                  </a:extLst>
                </a:gridCol>
                <a:gridCol w="1078876">
                  <a:extLst>
                    <a:ext uri="{9D8B030D-6E8A-4147-A177-3AD203B41FA5}">
                      <a16:colId xmlns:a16="http://schemas.microsoft.com/office/drawing/2014/main" val="3368217037"/>
                    </a:ext>
                  </a:extLst>
                </a:gridCol>
                <a:gridCol w="1078876">
                  <a:extLst>
                    <a:ext uri="{9D8B030D-6E8A-4147-A177-3AD203B41FA5}">
                      <a16:colId xmlns:a16="http://schemas.microsoft.com/office/drawing/2014/main" val="2473675970"/>
                    </a:ext>
                  </a:extLst>
                </a:gridCol>
                <a:gridCol w="1078876">
                  <a:extLst>
                    <a:ext uri="{9D8B030D-6E8A-4147-A177-3AD203B41FA5}">
                      <a16:colId xmlns:a16="http://schemas.microsoft.com/office/drawing/2014/main" val="3283656536"/>
                    </a:ext>
                  </a:extLst>
                </a:gridCol>
                <a:gridCol w="1078876">
                  <a:extLst>
                    <a:ext uri="{9D8B030D-6E8A-4147-A177-3AD203B41FA5}">
                      <a16:colId xmlns:a16="http://schemas.microsoft.com/office/drawing/2014/main" val="2094289062"/>
                    </a:ext>
                  </a:extLst>
                </a:gridCol>
              </a:tblGrid>
              <a:tr h="351609">
                <a:tc>
                  <a:txBody>
                    <a:bodyPr/>
                    <a:lstStyle/>
                    <a:p>
                      <a:endParaRPr lang="es-ES" sz="900" dirty="0"/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 err="1">
                          <a:solidFill>
                            <a:sysClr val="windowText" lastClr="000000"/>
                          </a:solidFill>
                        </a:rPr>
                        <a:t>Screening</a:t>
                      </a:r>
                      <a:endParaRPr lang="es-ES" sz="900" dirty="0">
                        <a:solidFill>
                          <a:sysClr val="windowText" lastClr="000000"/>
                        </a:solidFill>
                      </a:endParaRPr>
                    </a:p>
                    <a:p>
                      <a:pPr algn="ctr"/>
                      <a:r>
                        <a:rPr lang="es-ES" sz="900" dirty="0">
                          <a:solidFill>
                            <a:sysClr val="windowText" lastClr="000000"/>
                          </a:solidFill>
                        </a:rPr>
                        <a:t>(V0)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 err="1">
                          <a:solidFill>
                            <a:sysClr val="windowText" lastClr="000000"/>
                          </a:solidFill>
                        </a:rPr>
                        <a:t>Inclusion</a:t>
                      </a:r>
                      <a:endParaRPr lang="es-ES" sz="900" dirty="0">
                        <a:solidFill>
                          <a:sysClr val="windowText" lastClr="000000"/>
                        </a:solidFill>
                      </a:endParaRPr>
                    </a:p>
                    <a:p>
                      <a:pPr algn="ctr"/>
                      <a:r>
                        <a:rPr lang="es-ES" sz="900" dirty="0">
                          <a:solidFill>
                            <a:sysClr val="windowText" lastClr="000000"/>
                          </a:solidFill>
                        </a:rPr>
                        <a:t>(V1)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 err="1">
                          <a:solidFill>
                            <a:sysClr val="windowText" lastClr="000000"/>
                          </a:solidFill>
                        </a:rPr>
                        <a:t>Follow</a:t>
                      </a:r>
                      <a:r>
                        <a:rPr lang="es-ES" sz="900" dirty="0">
                          <a:solidFill>
                            <a:sysClr val="windowText" lastClr="000000"/>
                          </a:solidFill>
                        </a:rPr>
                        <a:t>-up</a:t>
                      </a:r>
                    </a:p>
                    <a:p>
                      <a:pPr algn="ctr"/>
                      <a:r>
                        <a:rPr lang="es-ES" sz="900" dirty="0">
                          <a:solidFill>
                            <a:sysClr val="windowText" lastClr="000000"/>
                          </a:solidFill>
                        </a:rPr>
                        <a:t>(V2)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>
                          <a:solidFill>
                            <a:sysClr val="windowText" lastClr="000000"/>
                          </a:solidFill>
                        </a:rPr>
                        <a:t>Final</a:t>
                      </a:r>
                    </a:p>
                    <a:p>
                      <a:pPr algn="ctr"/>
                      <a:r>
                        <a:rPr lang="es-ES" sz="900" dirty="0">
                          <a:solidFill>
                            <a:sysClr val="windowText" lastClr="000000"/>
                          </a:solidFill>
                        </a:rPr>
                        <a:t>(V3)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5467324"/>
                  </a:ext>
                </a:extLst>
              </a:tr>
              <a:tr h="210094">
                <a:tc>
                  <a:txBody>
                    <a:bodyPr/>
                    <a:lstStyle/>
                    <a:p>
                      <a:r>
                        <a:rPr lang="es-ES" sz="900" dirty="0" err="1"/>
                        <a:t>Clinical</a:t>
                      </a:r>
                      <a:r>
                        <a:rPr lang="es-ES" sz="900" dirty="0"/>
                        <a:t> interview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8031928"/>
                  </a:ext>
                </a:extLst>
              </a:tr>
              <a:tr h="351609">
                <a:tc>
                  <a:txBody>
                    <a:bodyPr/>
                    <a:lstStyle/>
                    <a:p>
                      <a:r>
                        <a:rPr lang="es-ES" sz="900" dirty="0" err="1"/>
                        <a:t>Blood</a:t>
                      </a:r>
                      <a:r>
                        <a:rPr lang="es-ES" sz="900" dirty="0"/>
                        <a:t> </a:t>
                      </a:r>
                      <a:r>
                        <a:rPr lang="es-ES" sz="900" dirty="0" err="1"/>
                        <a:t>pressure</a:t>
                      </a:r>
                      <a:r>
                        <a:rPr lang="es-ES" sz="900" dirty="0"/>
                        <a:t> and </a:t>
                      </a:r>
                      <a:r>
                        <a:rPr lang="es-ES" sz="900" dirty="0" err="1"/>
                        <a:t>anthropometry</a:t>
                      </a:r>
                      <a:endParaRPr lang="es-ES" sz="900" dirty="0"/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4745310"/>
                  </a:ext>
                </a:extLst>
              </a:tr>
              <a:tr h="351609">
                <a:tc>
                  <a:txBody>
                    <a:bodyPr/>
                    <a:lstStyle/>
                    <a:p>
                      <a:r>
                        <a:rPr lang="es-ES" sz="900" dirty="0" err="1"/>
                        <a:t>Magnetic</a:t>
                      </a:r>
                      <a:r>
                        <a:rPr lang="es-ES" sz="900" dirty="0"/>
                        <a:t> </a:t>
                      </a:r>
                      <a:r>
                        <a:rPr lang="es-ES" sz="900" dirty="0" err="1"/>
                        <a:t>ressonance</a:t>
                      </a:r>
                      <a:endParaRPr lang="es-ES" sz="900" dirty="0"/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s-ES" sz="900" dirty="0"/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s-ES" sz="900" dirty="0"/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1715461"/>
                  </a:ext>
                </a:extLst>
              </a:tr>
              <a:tr h="210094">
                <a:tc>
                  <a:txBody>
                    <a:bodyPr/>
                    <a:lstStyle/>
                    <a:p>
                      <a:r>
                        <a:rPr lang="es-ES" sz="900" dirty="0" err="1"/>
                        <a:t>Blood</a:t>
                      </a:r>
                      <a:r>
                        <a:rPr lang="es-ES" sz="900" dirty="0"/>
                        <a:t> </a:t>
                      </a:r>
                      <a:r>
                        <a:rPr lang="es-ES" sz="900" dirty="0" err="1"/>
                        <a:t>sample</a:t>
                      </a:r>
                      <a:endParaRPr lang="es-ES" sz="900" dirty="0"/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s-ES" sz="900" dirty="0"/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4514692"/>
                  </a:ext>
                </a:extLst>
              </a:tr>
              <a:tr h="210094">
                <a:tc>
                  <a:txBody>
                    <a:bodyPr/>
                    <a:lstStyle/>
                    <a:p>
                      <a:r>
                        <a:rPr lang="es-ES" sz="900" dirty="0" err="1"/>
                        <a:t>Stool</a:t>
                      </a:r>
                      <a:r>
                        <a:rPr lang="es-ES" sz="900" dirty="0"/>
                        <a:t> </a:t>
                      </a:r>
                      <a:r>
                        <a:rPr lang="es-ES" sz="900" dirty="0" err="1"/>
                        <a:t>collection</a:t>
                      </a:r>
                      <a:endParaRPr lang="es-ES" sz="900" dirty="0"/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s-ES" sz="900" dirty="0"/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s-ES" sz="900" dirty="0"/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8242533"/>
                  </a:ext>
                </a:extLst>
              </a:tr>
              <a:tr h="210094">
                <a:tc>
                  <a:txBody>
                    <a:bodyPr/>
                    <a:lstStyle/>
                    <a:p>
                      <a:r>
                        <a:rPr lang="es-ES" sz="900" dirty="0" err="1"/>
                        <a:t>Dietary</a:t>
                      </a:r>
                      <a:r>
                        <a:rPr lang="es-ES" sz="900" dirty="0"/>
                        <a:t> </a:t>
                      </a:r>
                      <a:r>
                        <a:rPr lang="es-ES" sz="900" dirty="0" err="1"/>
                        <a:t>assessment</a:t>
                      </a:r>
                      <a:endParaRPr lang="es-ES" sz="900" dirty="0"/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s-ES" sz="900" dirty="0"/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s-ES" sz="900" dirty="0"/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9363158"/>
                  </a:ext>
                </a:extLst>
              </a:tr>
              <a:tr h="351609">
                <a:tc>
                  <a:txBody>
                    <a:bodyPr/>
                    <a:lstStyle/>
                    <a:p>
                      <a:r>
                        <a:rPr lang="es-ES" sz="900" u="none" dirty="0" err="1"/>
                        <a:t>Physical</a:t>
                      </a:r>
                      <a:r>
                        <a:rPr lang="es-ES" sz="900" u="none" dirty="0"/>
                        <a:t> </a:t>
                      </a:r>
                      <a:r>
                        <a:rPr lang="es-ES" sz="900" u="none" dirty="0" err="1"/>
                        <a:t>activity</a:t>
                      </a:r>
                      <a:r>
                        <a:rPr lang="es-ES" sz="900" u="none" dirty="0"/>
                        <a:t> </a:t>
                      </a:r>
                      <a:r>
                        <a:rPr lang="es-ES" sz="900" u="none" dirty="0" err="1"/>
                        <a:t>assessment</a:t>
                      </a:r>
                      <a:endParaRPr lang="es-ES" sz="900" u="none" dirty="0"/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u="none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u="none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u="none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u="none" dirty="0"/>
                        <a:t>X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4046648"/>
                  </a:ext>
                </a:extLst>
              </a:tr>
            </a:tbl>
          </a:graphicData>
        </a:graphic>
      </p:graphicFrame>
      <p:cxnSp>
        <p:nvCxnSpPr>
          <p:cNvPr id="3" name="Conector recto de flecha 2">
            <a:extLst>
              <a:ext uri="{FF2B5EF4-FFF2-40B4-BE49-F238E27FC236}">
                <a16:creationId xmlns:a16="http://schemas.microsoft.com/office/drawing/2014/main" id="{59925F5E-E69D-8749-9D1B-062E2541B68E}"/>
              </a:ext>
            </a:extLst>
          </p:cNvPr>
          <p:cNvCxnSpPr>
            <a:stCxn id="53" idx="3"/>
            <a:endCxn id="48" idx="1"/>
          </p:cNvCxnSpPr>
          <p:nvPr/>
        </p:nvCxnSpPr>
        <p:spPr>
          <a:xfrm flipV="1">
            <a:off x="5594672" y="1875795"/>
            <a:ext cx="93919" cy="3170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Conector recto de flecha 26">
            <a:extLst>
              <a:ext uri="{FF2B5EF4-FFF2-40B4-BE49-F238E27FC236}">
                <a16:creationId xmlns:a16="http://schemas.microsoft.com/office/drawing/2014/main" id="{CBFD2838-D5C4-414F-A860-1896A0448B81}"/>
              </a:ext>
            </a:extLst>
          </p:cNvPr>
          <p:cNvCxnSpPr>
            <a:cxnSpLocks/>
            <a:stCxn id="48" idx="3"/>
            <a:endCxn id="49" idx="1"/>
          </p:cNvCxnSpPr>
          <p:nvPr/>
        </p:nvCxnSpPr>
        <p:spPr>
          <a:xfrm>
            <a:off x="6608894" y="1875794"/>
            <a:ext cx="93919" cy="0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Conector recto de flecha 27">
            <a:extLst>
              <a:ext uri="{FF2B5EF4-FFF2-40B4-BE49-F238E27FC236}">
                <a16:creationId xmlns:a16="http://schemas.microsoft.com/office/drawing/2014/main" id="{0AEE2FD9-463B-2E40-BDD3-28DEFCD4C061}"/>
              </a:ext>
            </a:extLst>
          </p:cNvPr>
          <p:cNvCxnSpPr>
            <a:cxnSpLocks/>
            <a:stCxn id="59" idx="3"/>
            <a:endCxn id="55" idx="1"/>
          </p:cNvCxnSpPr>
          <p:nvPr/>
        </p:nvCxnSpPr>
        <p:spPr>
          <a:xfrm>
            <a:off x="5576888" y="3071109"/>
            <a:ext cx="111703" cy="399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Conector recto de flecha 29">
            <a:extLst>
              <a:ext uri="{FF2B5EF4-FFF2-40B4-BE49-F238E27FC236}">
                <a16:creationId xmlns:a16="http://schemas.microsoft.com/office/drawing/2014/main" id="{E64D620F-1E7D-EA43-BD7C-0BB8B5C3C8C7}"/>
              </a:ext>
            </a:extLst>
          </p:cNvPr>
          <p:cNvCxnSpPr>
            <a:cxnSpLocks/>
            <a:stCxn id="55" idx="3"/>
            <a:endCxn id="56" idx="1"/>
          </p:cNvCxnSpPr>
          <p:nvPr/>
        </p:nvCxnSpPr>
        <p:spPr>
          <a:xfrm flipV="1">
            <a:off x="6591110" y="3071109"/>
            <a:ext cx="111703" cy="399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Rectángulo 16">
            <a:extLst>
              <a:ext uri="{FF2B5EF4-FFF2-40B4-BE49-F238E27FC236}">
                <a16:creationId xmlns:a16="http://schemas.microsoft.com/office/drawing/2014/main" id="{EDDA99A4-4C5A-F94D-8645-CC40DE0BDF6E}"/>
              </a:ext>
            </a:extLst>
          </p:cNvPr>
          <p:cNvSpPr/>
          <p:nvPr/>
        </p:nvSpPr>
        <p:spPr>
          <a:xfrm>
            <a:off x="2319286" y="2579744"/>
            <a:ext cx="554960" cy="21929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altLang="es-ES" sz="825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n=</a:t>
            </a:r>
            <a:r>
              <a:rPr lang="en-CA" altLang="es-ES" sz="825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8</a:t>
            </a:r>
            <a:r>
              <a:rPr lang="en-CA" altLang="es-ES" sz="825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s-ES" sz="825" dirty="0"/>
          </a:p>
        </p:txBody>
      </p:sp>
      <p:sp>
        <p:nvSpPr>
          <p:cNvPr id="18" name="Rectángulo 17">
            <a:extLst>
              <a:ext uri="{FF2B5EF4-FFF2-40B4-BE49-F238E27FC236}">
                <a16:creationId xmlns:a16="http://schemas.microsoft.com/office/drawing/2014/main" id="{053E48C8-EA8D-EA44-8033-D9DE834D6699}"/>
              </a:ext>
            </a:extLst>
          </p:cNvPr>
          <p:cNvSpPr/>
          <p:nvPr/>
        </p:nvSpPr>
        <p:spPr>
          <a:xfrm>
            <a:off x="3574484" y="2565192"/>
            <a:ext cx="554960" cy="21929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altLang="es-ES" sz="825" dirty="0">
                <a:latin typeface="Arial" panose="020B0604020202020204" pitchFamily="34" charset="0"/>
                <a:cs typeface="Times New Roman" panose="02020603050405020304" pitchFamily="18" charset="0"/>
              </a:rPr>
              <a:t>(n=</a:t>
            </a:r>
            <a:r>
              <a:rPr lang="en-CA" altLang="es-ES" sz="825" b="1" dirty="0">
                <a:latin typeface="Arial" panose="020B0604020202020204" pitchFamily="34" charset="0"/>
                <a:cs typeface="Times New Roman" panose="02020603050405020304" pitchFamily="18" charset="0"/>
              </a:rPr>
              <a:t>120</a:t>
            </a:r>
            <a:r>
              <a:rPr lang="en-CA" altLang="es-ES" sz="825" dirty="0">
                <a:latin typeface="Arial" panose="020B0604020202020204" pitchFamily="34" charset="0"/>
                <a:cs typeface="Times New Roman" panose="02020603050405020304" pitchFamily="18" charset="0"/>
              </a:rPr>
              <a:t>)</a:t>
            </a:r>
            <a:endParaRPr lang="es-ES" sz="825" dirty="0"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Rectángulo 18">
            <a:extLst>
              <a:ext uri="{FF2B5EF4-FFF2-40B4-BE49-F238E27FC236}">
                <a16:creationId xmlns:a16="http://schemas.microsoft.com/office/drawing/2014/main" id="{79B00906-6E8C-9D41-BE9E-405AC302E9CA}"/>
              </a:ext>
            </a:extLst>
          </p:cNvPr>
          <p:cNvSpPr/>
          <p:nvPr/>
        </p:nvSpPr>
        <p:spPr>
          <a:xfrm>
            <a:off x="6339678" y="1140925"/>
            <a:ext cx="495649" cy="21929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CA" altLang="es-ES" sz="825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</a:t>
            </a:r>
            <a:r>
              <a:rPr lang="en-CA" altLang="es-ES" sz="825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0</a:t>
            </a:r>
            <a:r>
              <a:rPr lang="en-CA" altLang="es-ES" sz="825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CA" altLang="es-ES" sz="825" dirty="0"/>
          </a:p>
        </p:txBody>
      </p:sp>
      <p:sp>
        <p:nvSpPr>
          <p:cNvPr id="44" name="Rectángulo 43">
            <a:extLst>
              <a:ext uri="{FF2B5EF4-FFF2-40B4-BE49-F238E27FC236}">
                <a16:creationId xmlns:a16="http://schemas.microsoft.com/office/drawing/2014/main" id="{594285D1-708B-F449-87C3-C935A1901CF7}"/>
              </a:ext>
            </a:extLst>
          </p:cNvPr>
          <p:cNvSpPr/>
          <p:nvPr/>
        </p:nvSpPr>
        <p:spPr>
          <a:xfrm>
            <a:off x="6350154" y="2309097"/>
            <a:ext cx="495649" cy="21929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CA" altLang="es-ES" sz="825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</a:t>
            </a:r>
            <a:r>
              <a:rPr lang="en-CA" altLang="es-ES" sz="825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0</a:t>
            </a:r>
            <a:r>
              <a:rPr lang="en-CA" altLang="es-ES" sz="825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CA" altLang="es-ES" sz="825" dirty="0"/>
          </a:p>
        </p:txBody>
      </p:sp>
      <p:sp>
        <p:nvSpPr>
          <p:cNvPr id="2" name="Rectángulo 1">
            <a:extLst>
              <a:ext uri="{FF2B5EF4-FFF2-40B4-BE49-F238E27FC236}">
                <a16:creationId xmlns:a16="http://schemas.microsoft.com/office/drawing/2014/main" id="{F710FBE6-4820-3240-BFAF-1DC146227D94}"/>
              </a:ext>
            </a:extLst>
          </p:cNvPr>
          <p:cNvSpPr/>
          <p:nvPr/>
        </p:nvSpPr>
        <p:spPr>
          <a:xfrm>
            <a:off x="6710876" y="1614334"/>
            <a:ext cx="912236" cy="499900"/>
          </a:xfrm>
          <a:prstGeom prst="rect">
            <a:avLst/>
          </a:prstGeom>
          <a:noFill/>
          <a:ln w="571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350"/>
          </a:p>
        </p:txBody>
      </p:sp>
      <p:sp>
        <p:nvSpPr>
          <p:cNvPr id="34" name="Rectángulo 33">
            <a:extLst>
              <a:ext uri="{FF2B5EF4-FFF2-40B4-BE49-F238E27FC236}">
                <a16:creationId xmlns:a16="http://schemas.microsoft.com/office/drawing/2014/main" id="{EE4BE1DC-1E82-BB4D-88E8-9C0EB67F81BF}"/>
              </a:ext>
            </a:extLst>
          </p:cNvPr>
          <p:cNvSpPr/>
          <p:nvPr/>
        </p:nvSpPr>
        <p:spPr>
          <a:xfrm>
            <a:off x="6712617" y="2811048"/>
            <a:ext cx="902520" cy="504371"/>
          </a:xfrm>
          <a:prstGeom prst="rect">
            <a:avLst/>
          </a:prstGeom>
          <a:noFill/>
          <a:ln w="571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350"/>
          </a:p>
        </p:txBody>
      </p:sp>
      <p:cxnSp>
        <p:nvCxnSpPr>
          <p:cNvPr id="6" name="Conector recto de flecha 5">
            <a:extLst>
              <a:ext uri="{FF2B5EF4-FFF2-40B4-BE49-F238E27FC236}">
                <a16:creationId xmlns:a16="http://schemas.microsoft.com/office/drawing/2014/main" id="{FCFCCAB0-CDCF-BB41-9A1F-9F87720B2145}"/>
              </a:ext>
            </a:extLst>
          </p:cNvPr>
          <p:cNvCxnSpPr>
            <a:cxnSpLocks/>
            <a:stCxn id="34" idx="3"/>
          </p:cNvCxnSpPr>
          <p:nvPr/>
        </p:nvCxnSpPr>
        <p:spPr>
          <a:xfrm flipV="1">
            <a:off x="7615140" y="2317803"/>
            <a:ext cx="708883" cy="7454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cto de flecha 35">
            <a:extLst>
              <a:ext uri="{FF2B5EF4-FFF2-40B4-BE49-F238E27FC236}">
                <a16:creationId xmlns:a16="http://schemas.microsoft.com/office/drawing/2014/main" id="{7341A172-1332-2242-84F7-E3A1E4F37C40}"/>
              </a:ext>
            </a:extLst>
          </p:cNvPr>
          <p:cNvCxnSpPr>
            <a:cxnSpLocks/>
          </p:cNvCxnSpPr>
          <p:nvPr/>
        </p:nvCxnSpPr>
        <p:spPr>
          <a:xfrm>
            <a:off x="7615140" y="1864288"/>
            <a:ext cx="708883" cy="3528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ectángulo 44">
            <a:extLst>
              <a:ext uri="{FF2B5EF4-FFF2-40B4-BE49-F238E27FC236}">
                <a16:creationId xmlns:a16="http://schemas.microsoft.com/office/drawing/2014/main" id="{92B8428B-336B-1549-9560-3E7F663321C0}"/>
              </a:ext>
            </a:extLst>
          </p:cNvPr>
          <p:cNvSpPr/>
          <p:nvPr/>
        </p:nvSpPr>
        <p:spPr>
          <a:xfrm rot="1757403">
            <a:off x="7764439" y="1884849"/>
            <a:ext cx="495649" cy="21929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altLang="es-ES" sz="825" dirty="0">
                <a:latin typeface="Arial" panose="020B0604020202020204" pitchFamily="34" charset="0"/>
                <a:cs typeface="Times New Roman" panose="02020603050405020304" pitchFamily="18" charset="0"/>
              </a:rPr>
              <a:t>(n=</a:t>
            </a:r>
            <a:r>
              <a:rPr lang="en-CA" altLang="es-ES" sz="825" b="1" dirty="0">
                <a:latin typeface="Arial" panose="020B0604020202020204" pitchFamily="34" charset="0"/>
                <a:cs typeface="Times New Roman" panose="02020603050405020304" pitchFamily="18" charset="0"/>
              </a:rPr>
              <a:t>16</a:t>
            </a:r>
            <a:r>
              <a:rPr lang="en-CA" altLang="es-ES" sz="825" dirty="0">
                <a:latin typeface="Arial" panose="020B0604020202020204" pitchFamily="34" charset="0"/>
                <a:cs typeface="Times New Roman" panose="02020603050405020304" pitchFamily="18" charset="0"/>
              </a:rPr>
              <a:t>)</a:t>
            </a:r>
            <a:endParaRPr lang="es-ES" sz="825" dirty="0"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7" name="Rectángulo 46">
            <a:extLst>
              <a:ext uri="{FF2B5EF4-FFF2-40B4-BE49-F238E27FC236}">
                <a16:creationId xmlns:a16="http://schemas.microsoft.com/office/drawing/2014/main" id="{9C3765F1-171E-BC4A-B119-7B9C195FF9CD}"/>
              </a:ext>
            </a:extLst>
          </p:cNvPr>
          <p:cNvSpPr/>
          <p:nvPr/>
        </p:nvSpPr>
        <p:spPr>
          <a:xfrm rot="19196824">
            <a:off x="7772826" y="2629974"/>
            <a:ext cx="495649" cy="21929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altLang="es-ES" sz="825" dirty="0">
                <a:latin typeface="Arial" panose="020B0604020202020204" pitchFamily="34" charset="0"/>
                <a:cs typeface="Times New Roman" panose="02020603050405020304" pitchFamily="18" charset="0"/>
              </a:rPr>
              <a:t>(n=</a:t>
            </a:r>
            <a:r>
              <a:rPr lang="en-CA" altLang="es-ES" sz="825" b="1" dirty="0">
                <a:latin typeface="Arial" panose="020B0604020202020204" pitchFamily="34" charset="0"/>
                <a:cs typeface="Times New Roman" panose="02020603050405020304" pitchFamily="18" charset="0"/>
              </a:rPr>
              <a:t>19</a:t>
            </a:r>
            <a:r>
              <a:rPr lang="en-CA" altLang="es-ES" sz="825" dirty="0">
                <a:latin typeface="Arial" panose="020B0604020202020204" pitchFamily="34" charset="0"/>
                <a:cs typeface="Times New Roman" panose="02020603050405020304" pitchFamily="18" charset="0"/>
              </a:rPr>
              <a:t>)</a:t>
            </a:r>
            <a:endParaRPr lang="es-ES" sz="825" dirty="0"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0" name="Tabla 49">
            <a:extLst>
              <a:ext uri="{FF2B5EF4-FFF2-40B4-BE49-F238E27FC236}">
                <a16:creationId xmlns:a16="http://schemas.microsoft.com/office/drawing/2014/main" id="{34431B2B-41F9-4646-B0C5-C397A1895F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1907406"/>
              </p:ext>
            </p:extLst>
          </p:nvPr>
        </p:nvGraphicFramePr>
        <p:xfrm>
          <a:off x="8354823" y="2030643"/>
          <a:ext cx="1767576" cy="112340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72133">
                  <a:extLst>
                    <a:ext uri="{9D8B030D-6E8A-4147-A177-3AD203B41FA5}">
                      <a16:colId xmlns:a16="http://schemas.microsoft.com/office/drawing/2014/main" val="511266432"/>
                    </a:ext>
                  </a:extLst>
                </a:gridCol>
                <a:gridCol w="398721">
                  <a:extLst>
                    <a:ext uri="{9D8B030D-6E8A-4147-A177-3AD203B41FA5}">
                      <a16:colId xmlns:a16="http://schemas.microsoft.com/office/drawing/2014/main" val="2094289062"/>
                    </a:ext>
                  </a:extLst>
                </a:gridCol>
                <a:gridCol w="390746">
                  <a:extLst>
                    <a:ext uri="{9D8B030D-6E8A-4147-A177-3AD203B41FA5}">
                      <a16:colId xmlns:a16="http://schemas.microsoft.com/office/drawing/2014/main" val="3379352328"/>
                    </a:ext>
                  </a:extLst>
                </a:gridCol>
                <a:gridCol w="405976">
                  <a:extLst>
                    <a:ext uri="{9D8B030D-6E8A-4147-A177-3AD203B41FA5}">
                      <a16:colId xmlns:a16="http://schemas.microsoft.com/office/drawing/2014/main" val="3819537033"/>
                    </a:ext>
                  </a:extLst>
                </a:gridCol>
              </a:tblGrid>
              <a:tr h="210094">
                <a:tc>
                  <a:txBody>
                    <a:bodyPr/>
                    <a:lstStyle/>
                    <a:p>
                      <a:endParaRPr lang="es-ES" sz="900" dirty="0"/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s-ES" sz="900" dirty="0">
                          <a:solidFill>
                            <a:sysClr val="windowText" lastClr="000000"/>
                          </a:solidFill>
                        </a:rPr>
                        <a:t>Final (V3)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s-ES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s-ES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7360731"/>
                  </a:ext>
                </a:extLst>
              </a:tr>
              <a:tr h="210094">
                <a:tc>
                  <a:txBody>
                    <a:bodyPr/>
                    <a:lstStyle/>
                    <a:p>
                      <a:endParaRPr lang="es-ES" sz="900" dirty="0"/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>
                          <a:solidFill>
                            <a:sysClr val="windowText" lastClr="000000"/>
                          </a:solidFill>
                        </a:rPr>
                        <a:t>T0h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>
                          <a:solidFill>
                            <a:sysClr val="windowText" lastClr="000000"/>
                          </a:solidFill>
                        </a:rPr>
                        <a:t>T2h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>
                          <a:solidFill>
                            <a:sysClr val="windowText" lastClr="000000"/>
                          </a:solidFill>
                        </a:rPr>
                        <a:t>T4h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5467324"/>
                  </a:ext>
                </a:extLst>
              </a:tr>
              <a:tr h="351609">
                <a:tc>
                  <a:txBody>
                    <a:bodyPr/>
                    <a:lstStyle/>
                    <a:p>
                      <a:r>
                        <a:rPr lang="es-ES" sz="900" dirty="0" err="1"/>
                        <a:t>Blood</a:t>
                      </a:r>
                      <a:r>
                        <a:rPr lang="es-ES" sz="900" dirty="0"/>
                        <a:t> </a:t>
                      </a:r>
                      <a:r>
                        <a:rPr lang="es-ES" sz="900" dirty="0" err="1"/>
                        <a:t>pressure</a:t>
                      </a:r>
                      <a:endParaRPr lang="es-ES" sz="900" dirty="0"/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4745310"/>
                  </a:ext>
                </a:extLst>
              </a:tr>
              <a:tr h="351609">
                <a:tc>
                  <a:txBody>
                    <a:bodyPr/>
                    <a:lstStyle/>
                    <a:p>
                      <a:r>
                        <a:rPr lang="es-ES" sz="900" dirty="0" err="1"/>
                        <a:t>Blood</a:t>
                      </a:r>
                      <a:r>
                        <a:rPr lang="es-ES" sz="900" dirty="0"/>
                        <a:t> </a:t>
                      </a:r>
                      <a:r>
                        <a:rPr lang="es-ES" sz="900" dirty="0" err="1"/>
                        <a:t>sample</a:t>
                      </a:r>
                      <a:endParaRPr lang="es-ES" sz="900" dirty="0"/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/>
                        <a:t>X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4514692"/>
                  </a:ext>
                </a:extLst>
              </a:tr>
            </a:tbl>
          </a:graphicData>
        </a:graphic>
      </p:graphicFrame>
      <p:sp>
        <p:nvSpPr>
          <p:cNvPr id="41" name="Rectángulo 40">
            <a:extLst>
              <a:ext uri="{FF2B5EF4-FFF2-40B4-BE49-F238E27FC236}">
                <a16:creationId xmlns:a16="http://schemas.microsoft.com/office/drawing/2014/main" id="{03AEC4A1-8194-3149-A4AD-BCAC80F8C92B}"/>
              </a:ext>
            </a:extLst>
          </p:cNvPr>
          <p:cNvSpPr/>
          <p:nvPr/>
        </p:nvSpPr>
        <p:spPr>
          <a:xfrm>
            <a:off x="8354823" y="1423371"/>
            <a:ext cx="1763050" cy="1704555"/>
          </a:xfrm>
          <a:prstGeom prst="rect">
            <a:avLst/>
          </a:prstGeom>
          <a:noFill/>
          <a:ln w="571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endParaRPr lang="en-US" sz="900" dirty="0">
              <a:solidFill>
                <a:schemeClr val="tx1"/>
              </a:solidFill>
            </a:endParaRPr>
          </a:p>
          <a:p>
            <a:pPr algn="ctr"/>
            <a:r>
              <a:rPr lang="en-US" sz="1050" b="1" dirty="0">
                <a:solidFill>
                  <a:schemeClr val="tx1"/>
                </a:solidFill>
              </a:rPr>
              <a:t>Dose-response postprandial study</a:t>
            </a:r>
          </a:p>
        </p:txBody>
      </p:sp>
      <p:sp>
        <p:nvSpPr>
          <p:cNvPr id="83" name="Rectángulo 82">
            <a:extLst>
              <a:ext uri="{FF2B5EF4-FFF2-40B4-BE49-F238E27FC236}">
                <a16:creationId xmlns:a16="http://schemas.microsoft.com/office/drawing/2014/main" id="{F653BCA4-4B6A-FE4F-B977-35E01F3A3B63}"/>
              </a:ext>
            </a:extLst>
          </p:cNvPr>
          <p:cNvSpPr/>
          <p:nvPr/>
        </p:nvSpPr>
        <p:spPr>
          <a:xfrm>
            <a:off x="3489853" y="3502637"/>
            <a:ext cx="807055" cy="3123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s-ES" sz="1050" dirty="0">
              <a:noFill/>
            </a:endParaRPr>
          </a:p>
        </p:txBody>
      </p:sp>
      <p:sp>
        <p:nvSpPr>
          <p:cNvPr id="84" name="Rectángulo 83">
            <a:extLst>
              <a:ext uri="{FF2B5EF4-FFF2-40B4-BE49-F238E27FC236}">
                <a16:creationId xmlns:a16="http://schemas.microsoft.com/office/drawing/2014/main" id="{3C498FC3-3DE4-2C43-BAD7-99903DA47C7C}"/>
              </a:ext>
            </a:extLst>
          </p:cNvPr>
          <p:cNvSpPr/>
          <p:nvPr/>
        </p:nvSpPr>
        <p:spPr>
          <a:xfrm>
            <a:off x="4616313" y="3502637"/>
            <a:ext cx="807055" cy="3123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s-ES" sz="1050" dirty="0">
              <a:noFill/>
            </a:endParaRPr>
          </a:p>
        </p:txBody>
      </p:sp>
      <p:sp>
        <p:nvSpPr>
          <p:cNvPr id="85" name="Rectángulo 84">
            <a:extLst>
              <a:ext uri="{FF2B5EF4-FFF2-40B4-BE49-F238E27FC236}">
                <a16:creationId xmlns:a16="http://schemas.microsoft.com/office/drawing/2014/main" id="{83A821B4-5C02-5047-823F-BE1ABB5CC607}"/>
              </a:ext>
            </a:extLst>
          </p:cNvPr>
          <p:cNvSpPr/>
          <p:nvPr/>
        </p:nvSpPr>
        <p:spPr>
          <a:xfrm>
            <a:off x="5688591" y="3506917"/>
            <a:ext cx="807055" cy="3123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s-ES" sz="1050" dirty="0">
              <a:noFill/>
            </a:endParaRPr>
          </a:p>
        </p:txBody>
      </p:sp>
      <p:sp>
        <p:nvSpPr>
          <p:cNvPr id="86" name="Rectángulo 85">
            <a:extLst>
              <a:ext uri="{FF2B5EF4-FFF2-40B4-BE49-F238E27FC236}">
                <a16:creationId xmlns:a16="http://schemas.microsoft.com/office/drawing/2014/main" id="{1044BF2B-3D55-994A-9C38-BD428988E1AF}"/>
              </a:ext>
            </a:extLst>
          </p:cNvPr>
          <p:cNvSpPr/>
          <p:nvPr/>
        </p:nvSpPr>
        <p:spPr>
          <a:xfrm>
            <a:off x="6750545" y="3502637"/>
            <a:ext cx="807055" cy="3123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s-ES" sz="1050" dirty="0">
              <a:noFill/>
            </a:endParaRPr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9577B35C-3AC6-DC47-8BB9-52B57E1BCC5A}"/>
              </a:ext>
            </a:extLst>
          </p:cNvPr>
          <p:cNvSpPr txBox="1"/>
          <p:nvPr/>
        </p:nvSpPr>
        <p:spPr>
          <a:xfrm>
            <a:off x="1663151" y="6370983"/>
            <a:ext cx="2129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orting</a:t>
            </a:r>
            <a:r>
              <a:rPr lang="es-ES" dirty="0"/>
              <a:t> Figure S1</a:t>
            </a:r>
          </a:p>
        </p:txBody>
      </p:sp>
    </p:spTree>
    <p:extLst>
      <p:ext uri="{BB962C8B-B14F-4D97-AF65-F5344CB8AC3E}">
        <p14:creationId xmlns:p14="http://schemas.microsoft.com/office/powerpoint/2010/main" val="31264241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Imagen que contiene peine&#10;&#10;Descripción generada automáticamente">
            <a:extLst>
              <a:ext uri="{FF2B5EF4-FFF2-40B4-BE49-F238E27FC236}">
                <a16:creationId xmlns:a16="http://schemas.microsoft.com/office/drawing/2014/main" id="{B474AF2F-B02E-884D-A2D8-CAAF006FD2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3517" y="27854"/>
            <a:ext cx="3442126" cy="6802297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F31FB5EB-FC7A-D745-AA07-81F0AD4C7F4F}"/>
              </a:ext>
            </a:extLst>
          </p:cNvPr>
          <p:cNvSpPr txBox="1"/>
          <p:nvPr/>
        </p:nvSpPr>
        <p:spPr>
          <a:xfrm>
            <a:off x="1663151" y="6370983"/>
            <a:ext cx="2129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orting</a:t>
            </a:r>
            <a:r>
              <a:rPr lang="es-ES" dirty="0"/>
              <a:t> Figure S2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5D2C64C0-880A-A040-873D-F61C56D9055B}"/>
              </a:ext>
            </a:extLst>
          </p:cNvPr>
          <p:cNvSpPr txBox="1"/>
          <p:nvPr/>
        </p:nvSpPr>
        <p:spPr>
          <a:xfrm>
            <a:off x="6096003" y="205240"/>
            <a:ext cx="849049" cy="1846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s-ES" sz="600" dirty="0"/>
              <a:t>SIAP2 </a:t>
            </a:r>
            <a:r>
              <a:rPr lang="es-ES" sz="600" dirty="0" err="1"/>
              <a:t>group</a:t>
            </a:r>
            <a:endParaRPr lang="es-ES" sz="600" dirty="0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19E23663-6E73-D840-BC4F-F49CFB5B2C91}"/>
              </a:ext>
            </a:extLst>
          </p:cNvPr>
          <p:cNvSpPr txBox="1"/>
          <p:nvPr/>
        </p:nvSpPr>
        <p:spPr>
          <a:xfrm>
            <a:off x="5382844" y="159077"/>
            <a:ext cx="484556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s-ES" sz="600" dirty="0"/>
              <a:t>Placebo </a:t>
            </a:r>
            <a:r>
              <a:rPr lang="es-ES" sz="600" dirty="0" err="1"/>
              <a:t>group</a:t>
            </a:r>
            <a:endParaRPr lang="es-ES" sz="600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66CAE95E-51EE-4EA1-ADDC-831C3366D6D3}"/>
              </a:ext>
            </a:extLst>
          </p:cNvPr>
          <p:cNvSpPr txBox="1"/>
          <p:nvPr/>
        </p:nvSpPr>
        <p:spPr>
          <a:xfrm>
            <a:off x="5124252" y="495352"/>
            <a:ext cx="1076523" cy="18770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25000"/>
              </a:lnSpc>
            </a:pPr>
            <a:r>
              <a:rPr lang="es-ES" sz="500" kern="1300" dirty="0"/>
              <a:t>Lachnospiraceae_NK4A136_group</a:t>
            </a:r>
          </a:p>
          <a:p>
            <a:pPr algn="r">
              <a:lnSpc>
                <a:spcPct val="125000"/>
              </a:lnSpc>
            </a:pPr>
            <a:r>
              <a:rPr lang="es-ES" sz="500" kern="1300" dirty="0" err="1"/>
              <a:t>Ruminococcaceae</a:t>
            </a:r>
            <a:endParaRPr lang="es-ES" sz="500" kern="1300" dirty="0"/>
          </a:p>
          <a:p>
            <a:pPr algn="r">
              <a:lnSpc>
                <a:spcPct val="125000"/>
              </a:lnSpc>
            </a:pPr>
            <a:r>
              <a:rPr lang="es-ES" sz="500" i="1" kern="1300" dirty="0" err="1"/>
              <a:t>Faecalibacterium</a:t>
            </a:r>
            <a:r>
              <a:rPr lang="es-ES" sz="500" i="1" kern="1300" dirty="0"/>
              <a:t> </a:t>
            </a:r>
            <a:r>
              <a:rPr lang="es-ES" sz="500" i="1" kern="1300" dirty="0" err="1"/>
              <a:t>prausnitzii</a:t>
            </a:r>
            <a:endParaRPr lang="es-ES" sz="500" i="1" kern="1300" dirty="0"/>
          </a:p>
          <a:p>
            <a:pPr algn="r">
              <a:lnSpc>
                <a:spcPct val="125000"/>
              </a:lnSpc>
            </a:pPr>
            <a:r>
              <a:rPr lang="es-ES" sz="500" i="1" kern="1300" dirty="0" err="1"/>
              <a:t>Prevotella</a:t>
            </a:r>
            <a:r>
              <a:rPr lang="es-ES" sz="500" i="1" kern="1300" dirty="0"/>
              <a:t> 9</a:t>
            </a:r>
          </a:p>
          <a:p>
            <a:pPr algn="r">
              <a:lnSpc>
                <a:spcPct val="125000"/>
              </a:lnSpc>
            </a:pPr>
            <a:r>
              <a:rPr lang="es-ES" sz="500" kern="1300" dirty="0" err="1"/>
              <a:t>Lachnospiraceae</a:t>
            </a:r>
            <a:endParaRPr lang="es-ES" sz="500" kern="1300" dirty="0"/>
          </a:p>
          <a:p>
            <a:pPr algn="r">
              <a:lnSpc>
                <a:spcPct val="125000"/>
              </a:lnSpc>
            </a:pPr>
            <a:r>
              <a:rPr lang="es-ES" sz="500" i="1" kern="1300" dirty="0" err="1"/>
              <a:t>Prevotella</a:t>
            </a:r>
            <a:r>
              <a:rPr lang="es-ES" sz="500" i="1" kern="1300" dirty="0"/>
              <a:t> 9</a:t>
            </a:r>
          </a:p>
          <a:p>
            <a:pPr algn="r">
              <a:lnSpc>
                <a:spcPct val="125000"/>
              </a:lnSpc>
            </a:pPr>
            <a:r>
              <a:rPr lang="es-ES" sz="500" i="1" kern="1300" dirty="0" err="1"/>
              <a:t>Faecalibacterium</a:t>
            </a:r>
            <a:r>
              <a:rPr lang="es-ES" sz="500" i="1" kern="1300" dirty="0"/>
              <a:t> </a:t>
            </a:r>
            <a:r>
              <a:rPr lang="es-ES" sz="500" i="1" kern="1300" dirty="0" err="1"/>
              <a:t>prausnitzii</a:t>
            </a:r>
            <a:endParaRPr lang="es-ES" sz="500" i="1" kern="1300" dirty="0"/>
          </a:p>
          <a:p>
            <a:pPr algn="r">
              <a:lnSpc>
                <a:spcPct val="125000"/>
              </a:lnSpc>
            </a:pPr>
            <a:r>
              <a:rPr lang="es-ES" sz="500" i="1" kern="1300" dirty="0" err="1"/>
              <a:t>Roseburia</a:t>
            </a:r>
            <a:r>
              <a:rPr lang="es-ES" sz="500" i="1" kern="1300" dirty="0"/>
              <a:t> </a:t>
            </a:r>
            <a:r>
              <a:rPr lang="es-ES" sz="500" i="1" kern="1300" dirty="0" err="1"/>
              <a:t>inulinivorans</a:t>
            </a:r>
            <a:endParaRPr lang="es-ES" sz="500" i="1" kern="1300" dirty="0"/>
          </a:p>
          <a:p>
            <a:pPr algn="r">
              <a:lnSpc>
                <a:spcPct val="125000"/>
              </a:lnSpc>
            </a:pPr>
            <a:r>
              <a:rPr lang="es-ES" sz="500" i="1" kern="1300" dirty="0" err="1"/>
              <a:t>Blautia</a:t>
            </a:r>
            <a:r>
              <a:rPr lang="es-ES" sz="500" i="1" kern="1300" dirty="0"/>
              <a:t> </a:t>
            </a:r>
            <a:r>
              <a:rPr lang="es-ES" sz="500" i="1" kern="1300" dirty="0" err="1"/>
              <a:t>obeum</a:t>
            </a:r>
            <a:endParaRPr lang="es-ES" sz="500" i="1" kern="1300" dirty="0"/>
          </a:p>
          <a:p>
            <a:pPr algn="r">
              <a:lnSpc>
                <a:spcPct val="125000"/>
              </a:lnSpc>
            </a:pPr>
            <a:r>
              <a:rPr lang="es-ES" sz="500" i="1" kern="1300" dirty="0" err="1"/>
              <a:t>Holdemanella</a:t>
            </a:r>
            <a:r>
              <a:rPr lang="es-ES" sz="500" i="1" kern="1300" dirty="0"/>
              <a:t> </a:t>
            </a:r>
            <a:r>
              <a:rPr lang="es-ES" sz="500" i="1" kern="1300" dirty="0" err="1"/>
              <a:t>biformis</a:t>
            </a:r>
            <a:r>
              <a:rPr lang="es-ES" sz="500" i="1" kern="1300" dirty="0"/>
              <a:t> </a:t>
            </a:r>
            <a:r>
              <a:rPr lang="es-ES" sz="500" kern="1300" dirty="0"/>
              <a:t>DSM 3989</a:t>
            </a:r>
          </a:p>
          <a:p>
            <a:pPr algn="r">
              <a:lnSpc>
                <a:spcPct val="125000"/>
              </a:lnSpc>
            </a:pPr>
            <a:r>
              <a:rPr lang="es-ES" sz="500" i="1" kern="1300" dirty="0" err="1"/>
              <a:t>Prevotella</a:t>
            </a:r>
            <a:r>
              <a:rPr lang="es-ES" sz="500" i="1" kern="1300" dirty="0"/>
              <a:t> 9</a:t>
            </a:r>
          </a:p>
          <a:p>
            <a:pPr algn="r">
              <a:lnSpc>
                <a:spcPct val="125000"/>
              </a:lnSpc>
            </a:pPr>
            <a:r>
              <a:rPr lang="es-ES" sz="500" i="1" kern="1300" dirty="0" err="1"/>
              <a:t>Ruminiclostridium</a:t>
            </a:r>
            <a:r>
              <a:rPr lang="es-ES" sz="500" i="1" kern="1300" dirty="0"/>
              <a:t> 6</a:t>
            </a:r>
          </a:p>
          <a:p>
            <a:pPr algn="r">
              <a:lnSpc>
                <a:spcPct val="125000"/>
              </a:lnSpc>
            </a:pPr>
            <a:r>
              <a:rPr lang="es-ES" sz="500" i="1" kern="1300" dirty="0" err="1"/>
              <a:t>Blautia</a:t>
            </a:r>
            <a:r>
              <a:rPr lang="es-ES" sz="500" i="1" kern="1300" dirty="0"/>
              <a:t> </a:t>
            </a:r>
            <a:r>
              <a:rPr lang="es-ES" sz="500" i="1" kern="1300" dirty="0" err="1"/>
              <a:t>massiliensis</a:t>
            </a:r>
            <a:endParaRPr lang="es-ES" sz="500" i="1" kern="1300" dirty="0"/>
          </a:p>
          <a:p>
            <a:pPr algn="r">
              <a:lnSpc>
                <a:spcPct val="120000"/>
              </a:lnSpc>
            </a:pPr>
            <a:r>
              <a:rPr lang="es-ES" sz="500" i="1" kern="1300" dirty="0" err="1"/>
              <a:t>Prevotella</a:t>
            </a:r>
            <a:r>
              <a:rPr lang="es-ES" sz="500" i="1" kern="1300" dirty="0"/>
              <a:t> 9</a:t>
            </a:r>
          </a:p>
          <a:p>
            <a:pPr algn="r">
              <a:lnSpc>
                <a:spcPct val="120000"/>
              </a:lnSpc>
            </a:pPr>
            <a:r>
              <a:rPr lang="es-ES" sz="500" i="1" kern="1300" dirty="0" err="1"/>
              <a:t>Collinsella</a:t>
            </a:r>
            <a:r>
              <a:rPr lang="es-ES" sz="500" i="1" kern="1300" dirty="0"/>
              <a:t> </a:t>
            </a:r>
            <a:r>
              <a:rPr lang="es-ES" sz="500" i="1" kern="1300" dirty="0" err="1"/>
              <a:t>intestinalis</a:t>
            </a:r>
            <a:r>
              <a:rPr lang="es-ES" sz="500" i="1" kern="1300" dirty="0"/>
              <a:t> </a:t>
            </a:r>
            <a:r>
              <a:rPr lang="es-ES" sz="500" kern="1300" dirty="0"/>
              <a:t>DSM 13280</a:t>
            </a:r>
          </a:p>
          <a:p>
            <a:pPr algn="r">
              <a:lnSpc>
                <a:spcPct val="120000"/>
              </a:lnSpc>
            </a:pPr>
            <a:r>
              <a:rPr lang="es-ES" sz="500" i="1" kern="1300" dirty="0" err="1"/>
              <a:t>Lachnospiraceae</a:t>
            </a:r>
            <a:r>
              <a:rPr lang="es-ES" sz="500" kern="1300" dirty="0"/>
              <a:t> FCS020 </a:t>
            </a:r>
            <a:r>
              <a:rPr lang="es-ES" sz="500" kern="1300" dirty="0" err="1"/>
              <a:t>group</a:t>
            </a:r>
            <a:endParaRPr lang="es-ES" sz="500" kern="1300" dirty="0"/>
          </a:p>
          <a:p>
            <a:pPr algn="r">
              <a:lnSpc>
                <a:spcPct val="120000"/>
              </a:lnSpc>
            </a:pPr>
            <a:r>
              <a:rPr lang="es-ES" sz="500" i="1" kern="1300" dirty="0" err="1"/>
              <a:t>Christensenellaceae</a:t>
            </a:r>
            <a:r>
              <a:rPr lang="es-ES" sz="500" kern="1300" dirty="0"/>
              <a:t> R7 </a:t>
            </a:r>
            <a:r>
              <a:rPr lang="es-ES" sz="500" kern="1300" dirty="0" err="1"/>
              <a:t>group</a:t>
            </a:r>
            <a:endParaRPr lang="es-ES" sz="500" kern="1300" dirty="0"/>
          </a:p>
          <a:p>
            <a:pPr algn="r">
              <a:lnSpc>
                <a:spcPct val="110000"/>
              </a:lnSpc>
            </a:pPr>
            <a:r>
              <a:rPr lang="es-ES" sz="500" i="1" kern="1300" dirty="0" err="1"/>
              <a:t>Clostridium</a:t>
            </a:r>
            <a:r>
              <a:rPr lang="es-ES" sz="500" kern="1300" dirty="0"/>
              <a:t> sensu stricto 1</a:t>
            </a:r>
          </a:p>
          <a:p>
            <a:pPr algn="r">
              <a:lnSpc>
                <a:spcPct val="110000"/>
              </a:lnSpc>
            </a:pPr>
            <a:endParaRPr lang="es-ES" sz="500" kern="1300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9CA12A00-7FF5-4D4C-9964-5D55FAAA5C8A}"/>
              </a:ext>
            </a:extLst>
          </p:cNvPr>
          <p:cNvSpPr txBox="1"/>
          <p:nvPr/>
        </p:nvSpPr>
        <p:spPr>
          <a:xfrm>
            <a:off x="4124523" y="2184882"/>
            <a:ext cx="2076252" cy="950838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lnSpc>
                <a:spcPct val="125000"/>
              </a:lnSpc>
              <a:defRPr sz="500" kern="1300"/>
            </a:lvl1pPr>
          </a:lstStyle>
          <a:p>
            <a:pPr algn="r"/>
            <a:r>
              <a:rPr lang="es-ES" i="1" dirty="0" err="1"/>
              <a:t>Alloprevotella</a:t>
            </a:r>
            <a:endParaRPr lang="es-ES" i="1" dirty="0"/>
          </a:p>
          <a:p>
            <a:pPr algn="r"/>
            <a:r>
              <a:rPr lang="es-ES" dirty="0" err="1"/>
              <a:t>Clostridia</a:t>
            </a:r>
            <a:endParaRPr lang="es-ES" dirty="0"/>
          </a:p>
          <a:p>
            <a:pPr algn="r"/>
            <a:r>
              <a:rPr lang="es-ES" i="1" dirty="0" err="1"/>
              <a:t>Adlercreutzia</a:t>
            </a:r>
            <a:r>
              <a:rPr lang="es-ES" i="1" dirty="0"/>
              <a:t> </a:t>
            </a:r>
            <a:r>
              <a:rPr lang="es-ES" i="1" dirty="0" err="1"/>
              <a:t>equolifaciens</a:t>
            </a:r>
            <a:endParaRPr lang="es-ES" i="1" dirty="0"/>
          </a:p>
          <a:p>
            <a:pPr algn="r"/>
            <a:r>
              <a:rPr lang="es-ES" i="1" dirty="0" err="1"/>
              <a:t>Prevotella</a:t>
            </a:r>
            <a:r>
              <a:rPr lang="es-ES" i="1" dirty="0"/>
              <a:t> 9</a:t>
            </a:r>
          </a:p>
          <a:p>
            <a:pPr algn="r"/>
            <a:r>
              <a:rPr lang="es-ES" i="1" dirty="0" err="1"/>
              <a:t>Dialister</a:t>
            </a:r>
            <a:r>
              <a:rPr lang="es-ES" i="1" dirty="0"/>
              <a:t> </a:t>
            </a:r>
            <a:r>
              <a:rPr lang="es-ES" i="1" dirty="0" err="1"/>
              <a:t>invisus</a:t>
            </a:r>
            <a:r>
              <a:rPr lang="es-ES" dirty="0"/>
              <a:t> DSM 15470</a:t>
            </a:r>
          </a:p>
          <a:p>
            <a:pPr algn="r"/>
            <a:r>
              <a:rPr lang="es-ES" i="1" dirty="0" err="1"/>
              <a:t>Christensenellaceae</a:t>
            </a:r>
            <a:r>
              <a:rPr lang="es-ES" dirty="0"/>
              <a:t> R7 </a:t>
            </a:r>
            <a:r>
              <a:rPr lang="es-ES" dirty="0" err="1"/>
              <a:t>group</a:t>
            </a:r>
            <a:endParaRPr lang="es-ES" dirty="0"/>
          </a:p>
          <a:p>
            <a:pPr algn="r"/>
            <a:r>
              <a:rPr lang="es-ES" i="1" dirty="0" err="1"/>
              <a:t>Rikenellaceae</a:t>
            </a:r>
            <a:r>
              <a:rPr lang="es-ES" dirty="0"/>
              <a:t> RC9 </a:t>
            </a:r>
            <a:r>
              <a:rPr lang="es-ES" dirty="0" err="1"/>
              <a:t>gut</a:t>
            </a:r>
            <a:r>
              <a:rPr lang="es-ES" dirty="0"/>
              <a:t> </a:t>
            </a:r>
            <a:r>
              <a:rPr lang="es-ES" dirty="0" err="1"/>
              <a:t>group</a:t>
            </a:r>
            <a:endParaRPr lang="es-ES" dirty="0"/>
          </a:p>
          <a:p>
            <a:pPr algn="r"/>
            <a:r>
              <a:rPr lang="es-ES" i="1" dirty="0" err="1"/>
              <a:t>Anaerofilum</a:t>
            </a:r>
            <a:endParaRPr lang="es-ES" i="1" dirty="0"/>
          </a:p>
          <a:p>
            <a:pPr algn="r"/>
            <a:r>
              <a:rPr lang="es-ES" i="1" dirty="0" err="1"/>
              <a:t>Senegalimassilia</a:t>
            </a:r>
            <a:r>
              <a:rPr lang="es-ES" i="1" dirty="0"/>
              <a:t> anaerobia </a:t>
            </a:r>
            <a:r>
              <a:rPr lang="es-ES" dirty="0"/>
              <a:t>JC110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CB1CDAD7-2182-4C1A-88ED-77F57E9E0A73}"/>
              </a:ext>
            </a:extLst>
          </p:cNvPr>
          <p:cNvSpPr txBox="1"/>
          <p:nvPr/>
        </p:nvSpPr>
        <p:spPr>
          <a:xfrm>
            <a:off x="6627783" y="3037879"/>
            <a:ext cx="1197005" cy="1143198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lnSpc>
                <a:spcPct val="125000"/>
              </a:lnSpc>
              <a:defRPr sz="500" kern="1300"/>
            </a:lvl1pPr>
          </a:lstStyle>
          <a:p>
            <a:r>
              <a:rPr lang="es-ES" i="1" dirty="0" err="1"/>
              <a:t>Caproiciproducens</a:t>
            </a:r>
            <a:endParaRPr lang="es-ES" i="1" dirty="0"/>
          </a:p>
          <a:p>
            <a:r>
              <a:rPr lang="es-ES" i="1" dirty="0" err="1"/>
              <a:t>Hydrogenoanaerobacterium</a:t>
            </a:r>
            <a:endParaRPr lang="es-ES" i="1" dirty="0"/>
          </a:p>
          <a:p>
            <a:r>
              <a:rPr lang="es-ES" dirty="0" err="1"/>
              <a:t>Puniceicoccaceae</a:t>
            </a:r>
            <a:endParaRPr lang="es-ES" dirty="0"/>
          </a:p>
          <a:p>
            <a:r>
              <a:rPr lang="es-ES" dirty="0" err="1"/>
              <a:t>Victivallaceae</a:t>
            </a:r>
            <a:endParaRPr lang="es-ES" dirty="0"/>
          </a:p>
          <a:p>
            <a:r>
              <a:rPr lang="es-ES" i="1" dirty="0" err="1"/>
              <a:t>Ruminococcaceae</a:t>
            </a:r>
            <a:r>
              <a:rPr lang="es-ES" i="1" dirty="0"/>
              <a:t> </a:t>
            </a:r>
            <a:r>
              <a:rPr lang="es-ES" dirty="0"/>
              <a:t>UCG-010</a:t>
            </a:r>
          </a:p>
          <a:p>
            <a:r>
              <a:rPr lang="es-ES" i="1" dirty="0" err="1"/>
              <a:t>Ruminococcaceae</a:t>
            </a:r>
            <a:r>
              <a:rPr lang="es-ES" i="1" dirty="0"/>
              <a:t> </a:t>
            </a:r>
            <a:r>
              <a:rPr lang="es-ES" dirty="0"/>
              <a:t>UCG-010</a:t>
            </a:r>
          </a:p>
          <a:p>
            <a:r>
              <a:rPr lang="es-ES" i="1" dirty="0" err="1"/>
              <a:t>Ruminococcaceae</a:t>
            </a:r>
            <a:r>
              <a:rPr lang="es-ES" i="1" dirty="0"/>
              <a:t> </a:t>
            </a:r>
            <a:r>
              <a:rPr lang="es-ES" dirty="0"/>
              <a:t>UCG-009</a:t>
            </a:r>
          </a:p>
          <a:p>
            <a:r>
              <a:rPr lang="es-ES" dirty="0" err="1"/>
              <a:t>Lachnospiraceae</a:t>
            </a:r>
            <a:endParaRPr lang="es-ES" dirty="0"/>
          </a:p>
          <a:p>
            <a:r>
              <a:rPr lang="es-ES" i="1" dirty="0" err="1"/>
              <a:t>Butyricimonas</a:t>
            </a:r>
            <a:endParaRPr lang="es-ES" i="1" dirty="0"/>
          </a:p>
          <a:p>
            <a:r>
              <a:rPr lang="es-ES" i="1" dirty="0" err="1"/>
              <a:t>Phascolarctobacterium</a:t>
            </a:r>
            <a:endParaRPr lang="es-ES" i="1" dirty="0"/>
          </a:p>
          <a:p>
            <a:endParaRPr lang="es-ES" i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FD955CA4-A044-45F9-9170-A958732B4146}"/>
              </a:ext>
            </a:extLst>
          </p:cNvPr>
          <p:cNvSpPr txBox="1"/>
          <p:nvPr/>
        </p:nvSpPr>
        <p:spPr>
          <a:xfrm>
            <a:off x="6629522" y="3977914"/>
            <a:ext cx="1362676" cy="1335558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lnSpc>
                <a:spcPct val="125000"/>
              </a:lnSpc>
              <a:defRPr sz="500" i="1" kern="1300"/>
            </a:lvl1pPr>
          </a:lstStyle>
          <a:p>
            <a:r>
              <a:rPr lang="es-ES" dirty="0" err="1"/>
              <a:t>Ruminococcaceae</a:t>
            </a:r>
            <a:r>
              <a:rPr lang="es-ES" dirty="0"/>
              <a:t> NK4A214 </a:t>
            </a:r>
            <a:r>
              <a:rPr lang="es-ES" dirty="0" err="1"/>
              <a:t>group</a:t>
            </a:r>
            <a:endParaRPr lang="es-ES" dirty="0"/>
          </a:p>
          <a:p>
            <a:r>
              <a:rPr lang="es-ES" dirty="0" err="1"/>
              <a:t>Butyricicoccus</a:t>
            </a:r>
            <a:endParaRPr lang="es-ES" dirty="0"/>
          </a:p>
          <a:p>
            <a:r>
              <a:rPr lang="es-ES" dirty="0" err="1"/>
              <a:t>Defluviitaleaceae</a:t>
            </a:r>
            <a:r>
              <a:rPr lang="es-ES" dirty="0"/>
              <a:t> UCG-011</a:t>
            </a:r>
          </a:p>
          <a:p>
            <a:r>
              <a:rPr lang="es-ES" dirty="0" err="1"/>
              <a:t>Lachnoclostridium</a:t>
            </a:r>
            <a:endParaRPr lang="es-ES" dirty="0"/>
          </a:p>
          <a:p>
            <a:r>
              <a:rPr lang="es-ES" dirty="0" err="1"/>
              <a:t>Lachnospiraceae</a:t>
            </a:r>
            <a:endParaRPr lang="es-ES" dirty="0"/>
          </a:p>
          <a:p>
            <a:r>
              <a:rPr lang="es-ES" dirty="0" err="1"/>
              <a:t>Ruminococcaceae</a:t>
            </a:r>
            <a:r>
              <a:rPr lang="es-ES" dirty="0"/>
              <a:t> UCG-010</a:t>
            </a:r>
          </a:p>
          <a:p>
            <a:r>
              <a:rPr lang="es-ES" dirty="0" err="1"/>
              <a:t>Christensenellaceae</a:t>
            </a:r>
            <a:r>
              <a:rPr lang="es-ES" dirty="0"/>
              <a:t> R7 </a:t>
            </a:r>
            <a:r>
              <a:rPr lang="es-ES" dirty="0" err="1"/>
              <a:t>group</a:t>
            </a:r>
            <a:endParaRPr lang="es-ES" dirty="0"/>
          </a:p>
          <a:p>
            <a:r>
              <a:rPr lang="es-ES" dirty="0" err="1"/>
              <a:t>Ruminococcaceae</a:t>
            </a:r>
            <a:r>
              <a:rPr lang="es-ES" dirty="0"/>
              <a:t> UCG-010</a:t>
            </a:r>
          </a:p>
          <a:p>
            <a:r>
              <a:rPr lang="es-ES" dirty="0" err="1"/>
              <a:t>Butyricimonas</a:t>
            </a:r>
            <a:endParaRPr lang="es-ES" dirty="0"/>
          </a:p>
          <a:p>
            <a:r>
              <a:rPr lang="es-ES" dirty="0" err="1"/>
              <a:t>Paraprevotella</a:t>
            </a:r>
            <a:r>
              <a:rPr lang="es-ES" dirty="0"/>
              <a:t> clara</a:t>
            </a:r>
          </a:p>
          <a:p>
            <a:r>
              <a:rPr lang="es-ES" dirty="0" err="1"/>
              <a:t>Ruminococcaceae</a:t>
            </a:r>
            <a:endParaRPr lang="es-ES" dirty="0"/>
          </a:p>
          <a:p>
            <a:r>
              <a:rPr lang="es-ES" dirty="0" err="1"/>
              <a:t>Barnesiella</a:t>
            </a:r>
            <a:r>
              <a:rPr lang="es-ES" dirty="0"/>
              <a:t> </a:t>
            </a:r>
            <a:r>
              <a:rPr lang="es-ES" dirty="0" err="1"/>
              <a:t>intestinihominis</a:t>
            </a:r>
            <a:r>
              <a:rPr lang="es-ES" dirty="0"/>
              <a:t> YIT 11860</a:t>
            </a:r>
          </a:p>
          <a:p>
            <a:endParaRPr lang="es-ES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005297EE-AA76-48F0-95AA-E02604272A20}"/>
              </a:ext>
            </a:extLst>
          </p:cNvPr>
          <p:cNvSpPr txBox="1"/>
          <p:nvPr/>
        </p:nvSpPr>
        <p:spPr>
          <a:xfrm>
            <a:off x="6629522" y="5105546"/>
            <a:ext cx="1042988" cy="143173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lnSpc>
                <a:spcPct val="125000"/>
              </a:lnSpc>
              <a:defRPr sz="500" i="1" kern="1300"/>
            </a:lvl1pPr>
          </a:lstStyle>
          <a:p>
            <a:r>
              <a:rPr lang="es-ES" dirty="0" err="1"/>
              <a:t>Bacteroidales</a:t>
            </a:r>
            <a:endParaRPr lang="es-ES" dirty="0"/>
          </a:p>
          <a:p>
            <a:r>
              <a:rPr lang="es-ES" dirty="0" err="1"/>
              <a:t>Ruminococcaceae</a:t>
            </a:r>
            <a:r>
              <a:rPr lang="es-ES" dirty="0"/>
              <a:t> UCG-005</a:t>
            </a:r>
          </a:p>
          <a:p>
            <a:r>
              <a:rPr lang="es-ES" dirty="0" err="1"/>
              <a:t>Ruminiclostridium</a:t>
            </a:r>
            <a:r>
              <a:rPr lang="es-ES" dirty="0"/>
              <a:t> 5</a:t>
            </a:r>
          </a:p>
          <a:p>
            <a:r>
              <a:rPr lang="es-ES" dirty="0" err="1"/>
              <a:t>Butyricicoccus</a:t>
            </a:r>
            <a:endParaRPr lang="es-ES" dirty="0"/>
          </a:p>
          <a:p>
            <a:r>
              <a:rPr lang="es-ES" dirty="0" err="1"/>
              <a:t>Alistipes</a:t>
            </a:r>
            <a:r>
              <a:rPr lang="es-ES" dirty="0"/>
              <a:t> </a:t>
            </a:r>
            <a:r>
              <a:rPr lang="es-ES" dirty="0" err="1"/>
              <a:t>finegoldii</a:t>
            </a:r>
            <a:endParaRPr lang="es-ES" dirty="0"/>
          </a:p>
          <a:p>
            <a:r>
              <a:rPr lang="es-ES" dirty="0" err="1"/>
              <a:t>Paraprevotella</a:t>
            </a:r>
            <a:endParaRPr lang="es-ES" dirty="0"/>
          </a:p>
          <a:p>
            <a:r>
              <a:rPr lang="es-ES" dirty="0" err="1"/>
              <a:t>Ruminiclostridium</a:t>
            </a:r>
            <a:r>
              <a:rPr lang="es-ES" dirty="0"/>
              <a:t> 5</a:t>
            </a:r>
          </a:p>
          <a:p>
            <a:r>
              <a:rPr lang="es-ES" dirty="0" err="1"/>
              <a:t>Bacteroides</a:t>
            </a:r>
            <a:r>
              <a:rPr lang="es-ES" dirty="0"/>
              <a:t> </a:t>
            </a:r>
            <a:r>
              <a:rPr lang="es-ES" dirty="0" err="1"/>
              <a:t>clarus</a:t>
            </a:r>
            <a:endParaRPr lang="es-ES" dirty="0"/>
          </a:p>
          <a:p>
            <a:r>
              <a:rPr lang="es-ES" dirty="0" err="1"/>
              <a:t>Alistipes</a:t>
            </a:r>
            <a:r>
              <a:rPr lang="es-ES" dirty="0"/>
              <a:t> </a:t>
            </a:r>
            <a:r>
              <a:rPr lang="es-ES" dirty="0" err="1"/>
              <a:t>finegoldii</a:t>
            </a:r>
            <a:endParaRPr lang="es-ES" dirty="0"/>
          </a:p>
          <a:p>
            <a:r>
              <a:rPr lang="es-ES" dirty="0" err="1"/>
              <a:t>Coprococcus</a:t>
            </a:r>
            <a:r>
              <a:rPr lang="es-ES" dirty="0"/>
              <a:t> 2</a:t>
            </a:r>
          </a:p>
          <a:p>
            <a:r>
              <a:rPr lang="es-ES" dirty="0" err="1"/>
              <a:t>Parabacteroides</a:t>
            </a:r>
            <a:r>
              <a:rPr lang="es-ES" dirty="0"/>
              <a:t> </a:t>
            </a:r>
            <a:r>
              <a:rPr lang="es-ES" dirty="0" err="1"/>
              <a:t>distasonis</a:t>
            </a:r>
            <a:endParaRPr lang="es-ES" dirty="0"/>
          </a:p>
          <a:p>
            <a:r>
              <a:rPr lang="es-ES" i="0" dirty="0" err="1"/>
              <a:t>Ruminococcaceae</a:t>
            </a:r>
            <a:endParaRPr lang="es-ES" i="0" dirty="0"/>
          </a:p>
          <a:p>
            <a:r>
              <a:rPr lang="es-ES" dirty="0" err="1"/>
              <a:t>Bacteroides</a:t>
            </a:r>
            <a:r>
              <a:rPr lang="es-ES" dirty="0"/>
              <a:t> </a:t>
            </a:r>
            <a:r>
              <a:rPr lang="es-ES" dirty="0" err="1"/>
              <a:t>eggerthii</a:t>
            </a:r>
            <a:endParaRPr lang="es-ES" dirty="0"/>
          </a:p>
          <a:p>
            <a:r>
              <a:rPr lang="es-ES" dirty="0" err="1"/>
              <a:t>Phascolarctobacterium</a:t>
            </a:r>
            <a:r>
              <a:rPr lang="es-ES" dirty="0"/>
              <a:t> </a:t>
            </a:r>
            <a:r>
              <a:rPr lang="es-ES" dirty="0" err="1"/>
              <a:t>faecium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7431518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>
            <a:extLst>
              <a:ext uri="{FF2B5EF4-FFF2-40B4-BE49-F238E27FC236}">
                <a16:creationId xmlns:a16="http://schemas.microsoft.com/office/drawing/2014/main" id="{079831E5-5B0C-42A8-B73A-BF1FD53782A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2476" t="11820" r="15715" b="6910"/>
          <a:stretch/>
        </p:blipFill>
        <p:spPr>
          <a:xfrm>
            <a:off x="3329758" y="65699"/>
            <a:ext cx="6480992" cy="6792301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73B0DE1A-ACFE-BA43-A97C-6C1D4888B174}"/>
              </a:ext>
            </a:extLst>
          </p:cNvPr>
          <p:cNvSpPr txBox="1"/>
          <p:nvPr/>
        </p:nvSpPr>
        <p:spPr>
          <a:xfrm>
            <a:off x="1663151" y="6370983"/>
            <a:ext cx="2129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orting</a:t>
            </a:r>
            <a:r>
              <a:rPr lang="es-ES" dirty="0"/>
              <a:t> Figure S3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435DABC9-3D5E-4452-B391-07C0B3DD50C2}"/>
              </a:ext>
            </a:extLst>
          </p:cNvPr>
          <p:cNvSpPr txBox="1"/>
          <p:nvPr/>
        </p:nvSpPr>
        <p:spPr>
          <a:xfrm>
            <a:off x="3439886" y="73810"/>
            <a:ext cx="1384663" cy="2539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050"/>
              <a:t>Association index (r)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F61E5445-4D12-4EA8-BB8F-50CA712DCF8E}"/>
              </a:ext>
            </a:extLst>
          </p:cNvPr>
          <p:cNvSpPr txBox="1"/>
          <p:nvPr/>
        </p:nvSpPr>
        <p:spPr>
          <a:xfrm>
            <a:off x="9428042" y="1417513"/>
            <a:ext cx="2405817" cy="4369401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lnSpc>
                <a:spcPct val="125000"/>
              </a:lnSpc>
              <a:defRPr sz="500" kern="1300"/>
            </a:lvl1pPr>
          </a:lstStyle>
          <a:p>
            <a:pPr>
              <a:lnSpc>
                <a:spcPct val="140000"/>
              </a:lnSpc>
            </a:pPr>
            <a:r>
              <a:rPr lang="es-ES" sz="1050" i="1" dirty="0"/>
              <a:t>Prevotella_9</a:t>
            </a:r>
          </a:p>
          <a:p>
            <a:pPr>
              <a:lnSpc>
                <a:spcPct val="140000"/>
              </a:lnSpc>
            </a:pPr>
            <a:r>
              <a:rPr lang="es-ES" sz="1050" i="1" dirty="0" err="1"/>
              <a:t>Roseburia</a:t>
            </a:r>
            <a:r>
              <a:rPr lang="es-ES" sz="1050" i="1" dirty="0"/>
              <a:t> </a:t>
            </a:r>
            <a:r>
              <a:rPr lang="es-ES" sz="1050" i="1" dirty="0" err="1"/>
              <a:t>inulinivorans</a:t>
            </a:r>
            <a:endParaRPr lang="es-ES" sz="1050" i="1" dirty="0"/>
          </a:p>
          <a:p>
            <a:pPr>
              <a:lnSpc>
                <a:spcPct val="140000"/>
              </a:lnSpc>
            </a:pPr>
            <a:r>
              <a:rPr lang="es-ES" sz="1050" i="1" dirty="0" err="1"/>
              <a:t>Phascolarctobacterium</a:t>
            </a:r>
            <a:r>
              <a:rPr lang="es-ES" sz="1050" i="1" dirty="0"/>
              <a:t> </a:t>
            </a:r>
            <a:r>
              <a:rPr lang="es-ES" sz="1050" i="1" dirty="0" err="1"/>
              <a:t>faecium</a:t>
            </a:r>
            <a:endParaRPr lang="es-ES" sz="1050" i="1" dirty="0"/>
          </a:p>
          <a:p>
            <a:pPr>
              <a:lnSpc>
                <a:spcPct val="140000"/>
              </a:lnSpc>
            </a:pPr>
            <a:r>
              <a:rPr lang="es-ES" sz="1050" i="1" dirty="0" err="1"/>
              <a:t>Romboutsia</a:t>
            </a:r>
            <a:r>
              <a:rPr lang="es-ES" sz="1050" i="1" dirty="0"/>
              <a:t> </a:t>
            </a:r>
            <a:r>
              <a:rPr lang="es-ES" sz="1050" i="1" dirty="0" err="1"/>
              <a:t>timonensis</a:t>
            </a:r>
            <a:endParaRPr lang="es-ES" sz="1050" i="1" dirty="0"/>
          </a:p>
          <a:p>
            <a:pPr>
              <a:lnSpc>
                <a:spcPct val="140000"/>
              </a:lnSpc>
            </a:pPr>
            <a:r>
              <a:rPr lang="es-ES" sz="1050" i="1" dirty="0"/>
              <a:t>Prevotella_9</a:t>
            </a:r>
          </a:p>
          <a:p>
            <a:pPr>
              <a:lnSpc>
                <a:spcPct val="140000"/>
              </a:lnSpc>
            </a:pPr>
            <a:r>
              <a:rPr lang="es-ES" sz="1050" dirty="0" err="1"/>
              <a:t>Puniceicoccaceae</a:t>
            </a:r>
            <a:endParaRPr lang="es-ES" sz="1050" dirty="0"/>
          </a:p>
          <a:p>
            <a:pPr>
              <a:lnSpc>
                <a:spcPct val="140000"/>
              </a:lnSpc>
            </a:pPr>
            <a:r>
              <a:rPr lang="es-ES" sz="1050" i="1" dirty="0"/>
              <a:t>Prevotella_9</a:t>
            </a:r>
          </a:p>
          <a:p>
            <a:pPr>
              <a:lnSpc>
                <a:spcPct val="140000"/>
              </a:lnSpc>
            </a:pPr>
            <a:r>
              <a:rPr lang="es-ES" sz="1050" i="1" dirty="0"/>
              <a:t>Prevotella_9</a:t>
            </a:r>
          </a:p>
          <a:p>
            <a:pPr>
              <a:lnSpc>
                <a:spcPct val="140000"/>
              </a:lnSpc>
            </a:pPr>
            <a:r>
              <a:rPr lang="es-ES" sz="1050" i="1" dirty="0" err="1"/>
              <a:t>Hydrogenoanaerobacterium</a:t>
            </a:r>
            <a:endParaRPr lang="es-ES" sz="1050" i="1" dirty="0"/>
          </a:p>
          <a:p>
            <a:pPr>
              <a:lnSpc>
                <a:spcPct val="140000"/>
              </a:lnSpc>
            </a:pPr>
            <a:r>
              <a:rPr lang="es-ES" sz="1050" dirty="0" err="1"/>
              <a:t>Lachnospiraceae</a:t>
            </a:r>
            <a:endParaRPr lang="es-ES" sz="1050" dirty="0"/>
          </a:p>
          <a:p>
            <a:pPr>
              <a:lnSpc>
                <a:spcPct val="140000"/>
              </a:lnSpc>
            </a:pPr>
            <a:r>
              <a:rPr lang="es-ES" sz="1050" dirty="0" err="1"/>
              <a:t>Lachnospiraceae</a:t>
            </a:r>
            <a:endParaRPr lang="es-ES" sz="1050" dirty="0"/>
          </a:p>
          <a:p>
            <a:pPr>
              <a:lnSpc>
                <a:spcPct val="140000"/>
              </a:lnSpc>
            </a:pPr>
            <a:r>
              <a:rPr lang="es-ES" sz="1050" i="1" dirty="0" err="1"/>
              <a:t>Faecalibacterium</a:t>
            </a:r>
            <a:r>
              <a:rPr lang="es-ES" sz="1050" i="1" dirty="0"/>
              <a:t> </a:t>
            </a:r>
            <a:r>
              <a:rPr lang="es-ES" sz="1050" i="1" dirty="0" err="1"/>
              <a:t>prausnitzii</a:t>
            </a:r>
            <a:endParaRPr lang="es-ES" sz="1050" i="1" dirty="0"/>
          </a:p>
          <a:p>
            <a:pPr>
              <a:lnSpc>
                <a:spcPct val="140000"/>
              </a:lnSpc>
            </a:pPr>
            <a:r>
              <a:rPr lang="es-ES" sz="1050" i="1" dirty="0" err="1"/>
              <a:t>Barnesiella</a:t>
            </a:r>
            <a:r>
              <a:rPr lang="es-ES" sz="1050" i="1" dirty="0"/>
              <a:t> </a:t>
            </a:r>
            <a:r>
              <a:rPr lang="es-ES" sz="1050" i="1" dirty="0" err="1"/>
              <a:t>intestinihominis</a:t>
            </a:r>
            <a:r>
              <a:rPr lang="es-ES" sz="1050" i="1" dirty="0"/>
              <a:t> </a:t>
            </a:r>
            <a:r>
              <a:rPr lang="es-ES" sz="1050" dirty="0"/>
              <a:t>YIT 11860</a:t>
            </a:r>
          </a:p>
          <a:p>
            <a:pPr>
              <a:lnSpc>
                <a:spcPct val="140000"/>
              </a:lnSpc>
            </a:pPr>
            <a:r>
              <a:rPr lang="es-ES" sz="1050" i="1" dirty="0" err="1"/>
              <a:t>Ruminiclostridium</a:t>
            </a:r>
            <a:r>
              <a:rPr lang="es-ES" sz="1050" dirty="0"/>
              <a:t> 6</a:t>
            </a:r>
          </a:p>
          <a:p>
            <a:pPr>
              <a:lnSpc>
                <a:spcPct val="140000"/>
              </a:lnSpc>
            </a:pPr>
            <a:r>
              <a:rPr lang="es-ES" sz="1050" i="1" dirty="0" err="1"/>
              <a:t>Alistipes</a:t>
            </a:r>
            <a:r>
              <a:rPr lang="es-ES" sz="1050" i="1" dirty="0"/>
              <a:t> </a:t>
            </a:r>
            <a:r>
              <a:rPr lang="es-ES" sz="1050" i="1" dirty="0" err="1"/>
              <a:t>finegoldii</a:t>
            </a:r>
            <a:endParaRPr lang="es-ES" sz="1050" i="1" dirty="0"/>
          </a:p>
          <a:p>
            <a:pPr>
              <a:lnSpc>
                <a:spcPct val="140000"/>
              </a:lnSpc>
            </a:pPr>
            <a:r>
              <a:rPr lang="es-ES" sz="1050" dirty="0" err="1"/>
              <a:t>Ruminococcaceae</a:t>
            </a:r>
            <a:endParaRPr lang="es-ES" sz="1050" dirty="0"/>
          </a:p>
          <a:p>
            <a:pPr>
              <a:lnSpc>
                <a:spcPct val="140000"/>
              </a:lnSpc>
            </a:pPr>
            <a:r>
              <a:rPr lang="es-ES" sz="1050" i="1" dirty="0" err="1"/>
              <a:t>Ruminococcaceae</a:t>
            </a:r>
            <a:r>
              <a:rPr lang="es-ES" sz="1050" i="1" dirty="0"/>
              <a:t> </a:t>
            </a:r>
            <a:r>
              <a:rPr lang="es-ES" sz="1050" dirty="0"/>
              <a:t>UCG 010</a:t>
            </a:r>
          </a:p>
          <a:p>
            <a:pPr>
              <a:lnSpc>
                <a:spcPct val="140000"/>
              </a:lnSpc>
            </a:pPr>
            <a:r>
              <a:rPr lang="es-ES" sz="1050" i="1" dirty="0" err="1"/>
              <a:t>Ruminococcaceae</a:t>
            </a:r>
            <a:r>
              <a:rPr lang="es-ES" sz="1050" i="1" dirty="0"/>
              <a:t> </a:t>
            </a:r>
            <a:r>
              <a:rPr lang="es-ES" sz="1050" dirty="0"/>
              <a:t>UCG 005</a:t>
            </a:r>
          </a:p>
          <a:p>
            <a:pPr>
              <a:lnSpc>
                <a:spcPct val="140000"/>
              </a:lnSpc>
            </a:pPr>
            <a:r>
              <a:rPr lang="es-ES" sz="1050" dirty="0" err="1"/>
              <a:t>Lachnospiraceae</a:t>
            </a:r>
            <a:endParaRPr lang="es-ES" sz="1050" dirty="0"/>
          </a:p>
        </p:txBody>
      </p:sp>
    </p:spTree>
    <p:extLst>
      <p:ext uri="{BB962C8B-B14F-4D97-AF65-F5344CB8AC3E}">
        <p14:creationId xmlns:p14="http://schemas.microsoft.com/office/powerpoint/2010/main" val="39512787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Imagen 28">
            <a:extLst>
              <a:ext uri="{FF2B5EF4-FFF2-40B4-BE49-F238E27FC236}">
                <a16:creationId xmlns:a16="http://schemas.microsoft.com/office/drawing/2014/main" id="{E93B3DAD-D8A4-4BBD-9077-50F1C854C3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1024" t="12553" r="13976" b="5224"/>
          <a:stretch/>
        </p:blipFill>
        <p:spPr>
          <a:xfrm>
            <a:off x="4119887" y="1691526"/>
            <a:ext cx="4070840" cy="3765528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89FCC47A-BD6B-6046-958F-40022670D8F7}"/>
              </a:ext>
            </a:extLst>
          </p:cNvPr>
          <p:cNvSpPr txBox="1"/>
          <p:nvPr/>
        </p:nvSpPr>
        <p:spPr>
          <a:xfrm>
            <a:off x="890123" y="6269445"/>
            <a:ext cx="2129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orting</a:t>
            </a:r>
            <a:r>
              <a:rPr lang="es-ES" dirty="0"/>
              <a:t> Figure S4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B7FFF335-614F-A842-AE81-2EF6ADD695F9}"/>
              </a:ext>
            </a:extLst>
          </p:cNvPr>
          <p:cNvSpPr txBox="1"/>
          <p:nvPr/>
        </p:nvSpPr>
        <p:spPr>
          <a:xfrm>
            <a:off x="1134661" y="1661439"/>
            <a:ext cx="1884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S4.A    V1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7A5B0E0E-A117-F64A-B4EC-2C21EC0D907A}"/>
              </a:ext>
            </a:extLst>
          </p:cNvPr>
          <p:cNvSpPr txBox="1"/>
          <p:nvPr/>
        </p:nvSpPr>
        <p:spPr>
          <a:xfrm>
            <a:off x="4787526" y="1400946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S4.B   V3-SIAP2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B939E64E-D7D4-1642-B54E-D5D00C0857AD}"/>
              </a:ext>
            </a:extLst>
          </p:cNvPr>
          <p:cNvSpPr txBox="1"/>
          <p:nvPr/>
        </p:nvSpPr>
        <p:spPr>
          <a:xfrm>
            <a:off x="8708158" y="1424899"/>
            <a:ext cx="1975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S4.C    V3-PLACEBO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17BFD4A3-B3C6-46EB-8BEE-CB99B1084538}"/>
              </a:ext>
            </a:extLst>
          </p:cNvPr>
          <p:cNvSpPr txBox="1"/>
          <p:nvPr/>
        </p:nvSpPr>
        <p:spPr>
          <a:xfrm>
            <a:off x="7287248" y="4631563"/>
            <a:ext cx="41549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 dirty="0"/>
              <a:t>Men</a:t>
            </a:r>
            <a:r>
              <a:rPr lang="en-US" sz="1200" b="1" dirty="0"/>
              <a:t> 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7998C703-8E4D-4791-AB39-2EF16865016C}"/>
              </a:ext>
            </a:extLst>
          </p:cNvPr>
          <p:cNvSpPr txBox="1"/>
          <p:nvPr/>
        </p:nvSpPr>
        <p:spPr>
          <a:xfrm>
            <a:off x="7229888" y="4838945"/>
            <a:ext cx="62297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b="1" dirty="0"/>
              <a:t>Women  </a:t>
            </a:r>
          </a:p>
        </p:txBody>
      </p:sp>
      <p:pic>
        <p:nvPicPr>
          <p:cNvPr id="18" name="Imagen 17">
            <a:extLst>
              <a:ext uri="{FF2B5EF4-FFF2-40B4-BE49-F238E27FC236}">
                <a16:creationId xmlns:a16="http://schemas.microsoft.com/office/drawing/2014/main" id="{8AF29878-4214-4E84-8CB1-62589B776F5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1332" t="12619" r="24297" b="5833"/>
          <a:stretch/>
        </p:blipFill>
        <p:spPr>
          <a:xfrm>
            <a:off x="0" y="1661439"/>
            <a:ext cx="4221211" cy="3930766"/>
          </a:xfrm>
          <a:prstGeom prst="rect">
            <a:avLst/>
          </a:prstGeom>
        </p:spPr>
      </p:pic>
      <p:sp>
        <p:nvSpPr>
          <p:cNvPr id="30" name="CuadroTexto 29">
            <a:extLst>
              <a:ext uri="{FF2B5EF4-FFF2-40B4-BE49-F238E27FC236}">
                <a16:creationId xmlns:a16="http://schemas.microsoft.com/office/drawing/2014/main" id="{9615EB4A-15D4-4112-BD96-AECF92B831DB}"/>
              </a:ext>
            </a:extLst>
          </p:cNvPr>
          <p:cNvSpPr txBox="1"/>
          <p:nvPr/>
        </p:nvSpPr>
        <p:spPr>
          <a:xfrm>
            <a:off x="3348331" y="4535929"/>
            <a:ext cx="41549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 dirty="0"/>
              <a:t>Men</a:t>
            </a:r>
            <a:r>
              <a:rPr lang="en-US" sz="1200" b="1" dirty="0"/>
              <a:t> 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0201429E-19C9-4A52-862B-FD1F6CE6CA58}"/>
              </a:ext>
            </a:extLst>
          </p:cNvPr>
          <p:cNvSpPr txBox="1"/>
          <p:nvPr/>
        </p:nvSpPr>
        <p:spPr>
          <a:xfrm>
            <a:off x="3290971" y="4743311"/>
            <a:ext cx="69994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b="1" dirty="0"/>
              <a:t>Women  </a:t>
            </a:r>
          </a:p>
        </p:txBody>
      </p:sp>
      <p:pic>
        <p:nvPicPr>
          <p:cNvPr id="33" name="Imagen 32">
            <a:extLst>
              <a:ext uri="{FF2B5EF4-FFF2-40B4-BE49-F238E27FC236}">
                <a16:creationId xmlns:a16="http://schemas.microsoft.com/office/drawing/2014/main" id="{03136F39-F785-4745-8BCC-5F0386A57EF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0784" t="12214" r="23783" b="5930"/>
          <a:stretch/>
        </p:blipFill>
        <p:spPr>
          <a:xfrm>
            <a:off x="8097758" y="1702243"/>
            <a:ext cx="4136274" cy="3744095"/>
          </a:xfrm>
          <a:prstGeom prst="rect">
            <a:avLst/>
          </a:prstGeom>
        </p:spPr>
      </p:pic>
      <p:sp>
        <p:nvSpPr>
          <p:cNvPr id="23" name="CuadroTexto 22">
            <a:extLst>
              <a:ext uri="{FF2B5EF4-FFF2-40B4-BE49-F238E27FC236}">
                <a16:creationId xmlns:a16="http://schemas.microsoft.com/office/drawing/2014/main" id="{E67712DF-D80E-694A-83A6-3F2C15481681}"/>
              </a:ext>
            </a:extLst>
          </p:cNvPr>
          <p:cNvSpPr txBox="1"/>
          <p:nvPr/>
        </p:nvSpPr>
        <p:spPr>
          <a:xfrm>
            <a:off x="11435694" y="4643651"/>
            <a:ext cx="41549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 dirty="0"/>
              <a:t>Men</a:t>
            </a:r>
            <a:r>
              <a:rPr lang="en-US" sz="1200" b="1" dirty="0"/>
              <a:t> 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8185DB71-BAB9-DE4C-B869-0A8D17DF727E}"/>
              </a:ext>
            </a:extLst>
          </p:cNvPr>
          <p:cNvSpPr txBox="1"/>
          <p:nvPr/>
        </p:nvSpPr>
        <p:spPr>
          <a:xfrm>
            <a:off x="11378334" y="4851033"/>
            <a:ext cx="60182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b="1" dirty="0"/>
              <a:t>Women  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60BFA2FF-7C5C-4A5E-BF90-6787D1494089}"/>
              </a:ext>
            </a:extLst>
          </p:cNvPr>
          <p:cNvSpPr txBox="1"/>
          <p:nvPr/>
        </p:nvSpPr>
        <p:spPr>
          <a:xfrm>
            <a:off x="568346" y="1332911"/>
            <a:ext cx="1006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S4.A   V1</a:t>
            </a:r>
          </a:p>
        </p:txBody>
      </p:sp>
    </p:spTree>
    <p:extLst>
      <p:ext uri="{BB962C8B-B14F-4D97-AF65-F5344CB8AC3E}">
        <p14:creationId xmlns:p14="http://schemas.microsoft.com/office/powerpoint/2010/main" val="33832167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</TotalTime>
  <Words>363</Words>
  <Application>Microsoft Office PowerPoint</Application>
  <PresentationFormat>Panorámica</PresentationFormat>
  <Paragraphs>183</Paragraphs>
  <Slides>4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dit Companys Alemany</dc:creator>
  <cp:lastModifiedBy>Judit Companys Alemany</cp:lastModifiedBy>
  <cp:revision>8</cp:revision>
  <dcterms:created xsi:type="dcterms:W3CDTF">2021-03-09T10:08:03Z</dcterms:created>
  <dcterms:modified xsi:type="dcterms:W3CDTF">2022-03-27T17:51:12Z</dcterms:modified>
</cp:coreProperties>
</file>